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3679488" cy="14400213"/>
  <p:notesSz cx="6858000" cy="9144000"/>
  <p:defaultTextStyle>
    <a:defPPr>
      <a:defRPr lang="en-US"/>
    </a:defPPr>
    <a:lvl1pPr algn="l" defTabSz="331492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1pPr>
    <a:lvl2pPr marL="331492" algn="l" defTabSz="331492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2pPr>
    <a:lvl3pPr marL="662981" algn="l" defTabSz="331492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3pPr>
    <a:lvl4pPr marL="994472" algn="l" defTabSz="331492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4pPr>
    <a:lvl5pPr marL="1325963" algn="l" defTabSz="331492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5pPr>
    <a:lvl6pPr marL="1657453" algn="l" defTabSz="662981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6pPr>
    <a:lvl7pPr marL="1988945" algn="l" defTabSz="662981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7pPr>
    <a:lvl8pPr marL="2320435" algn="l" defTabSz="662981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8pPr>
    <a:lvl9pPr marL="2651925" algn="l" defTabSz="662981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36" userDrawn="1">
          <p15:clr>
            <a:srgbClr val="A4A3A4"/>
          </p15:clr>
        </p15:guide>
        <p15:guide id="2" pos="430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9694"/>
    <a:srgbClr val="DE006F"/>
    <a:srgbClr val="0033CC"/>
    <a:srgbClr val="FF3399"/>
    <a:srgbClr val="003399"/>
    <a:srgbClr val="FFFF66"/>
    <a:srgbClr val="FFCC66"/>
    <a:srgbClr val="66FF66"/>
    <a:srgbClr val="292929"/>
    <a:srgbClr val="4D4D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000" autoAdjust="0"/>
    <p:restoredTop sz="94434" autoAdjust="0"/>
  </p:normalViewPr>
  <p:slideViewPr>
    <p:cSldViewPr snapToGrid="0" snapToObjects="1">
      <p:cViewPr>
        <p:scale>
          <a:sx n="94" d="100"/>
          <a:sy n="94" d="100"/>
        </p:scale>
        <p:origin x="298" y="-4699"/>
      </p:cViewPr>
      <p:guideLst>
        <p:guide orient="horz" pos="4536"/>
        <p:guide pos="430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iana.V\Desktop\TRABAJOS%20MAC\Trab%20MASA%20microarrays\DATOS%20LOCs\2b-%20LOC%20Experiment%20UP%20IMMUNE%20LIST%20COMPLET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iana.V\Desktop\TRABAJOS%20MAC\Trab%20MASA%20microarrays\DATOS%20LOCs\2b-%20LOC%20Experiment%20UP%20IMMUNE%20LIST%20COMPLET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lected immune genes II'!$C$65</c:f>
              <c:strCache>
                <c:ptCount val="1"/>
                <c:pt idx="0">
                  <c:v>LPS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elected immune genes II'!$B$66:$B$86</c:f>
              <c:strCache>
                <c:ptCount val="21"/>
                <c:pt idx="0">
                  <c:v>Cd164</c:v>
                </c:pt>
                <c:pt idx="1">
                  <c:v>Cd200r2</c:v>
                </c:pt>
                <c:pt idx="2">
                  <c:v>Cd200r4</c:v>
                </c:pt>
                <c:pt idx="3">
                  <c:v>Cd209a</c:v>
                </c:pt>
                <c:pt idx="4">
                  <c:v>Cd209b</c:v>
                </c:pt>
                <c:pt idx="5">
                  <c:v>Cd38</c:v>
                </c:pt>
                <c:pt idx="6">
                  <c:v>Cd40</c:v>
                </c:pt>
                <c:pt idx="7">
                  <c:v>Cd69</c:v>
                </c:pt>
                <c:pt idx="8">
                  <c:v>Cd80</c:v>
                </c:pt>
                <c:pt idx="9">
                  <c:v>Cd83</c:v>
                </c:pt>
                <c:pt idx="10">
                  <c:v>Cd86</c:v>
                </c:pt>
                <c:pt idx="11">
                  <c:v>Fcgr1</c:v>
                </c:pt>
                <c:pt idx="12">
                  <c:v>Fcgr4</c:v>
                </c:pt>
                <c:pt idx="13">
                  <c:v>Fcmr</c:v>
                </c:pt>
                <c:pt idx="14">
                  <c:v>H2-K1</c:v>
                </c:pt>
                <c:pt idx="15">
                  <c:v>H2-M3</c:v>
                </c:pt>
                <c:pt idx="16">
                  <c:v>H2-Q10</c:v>
                </c:pt>
                <c:pt idx="17">
                  <c:v>H2-T10</c:v>
                </c:pt>
                <c:pt idx="18">
                  <c:v>H2-T22</c:v>
                </c:pt>
                <c:pt idx="19">
                  <c:v>Siglec1</c:v>
                </c:pt>
                <c:pt idx="20">
                  <c:v>Siglecf</c:v>
                </c:pt>
              </c:strCache>
            </c:strRef>
          </c:cat>
          <c:val>
            <c:numRef>
              <c:f>'Selected immune genes II'!$C$66:$C$86</c:f>
              <c:numCache>
                <c:formatCode>General</c:formatCode>
                <c:ptCount val="21"/>
                <c:pt idx="0">
                  <c:v>2.5442442999999999</c:v>
                </c:pt>
                <c:pt idx="1">
                  <c:v>2.6425299999999998</c:v>
                </c:pt>
                <c:pt idx="2">
                  <c:v>0</c:v>
                </c:pt>
                <c:pt idx="3">
                  <c:v>2.1572207999999899</c:v>
                </c:pt>
                <c:pt idx="4">
                  <c:v>0</c:v>
                </c:pt>
                <c:pt idx="5">
                  <c:v>1.0642103999999999</c:v>
                </c:pt>
                <c:pt idx="6">
                  <c:v>5.6757879999999998</c:v>
                </c:pt>
                <c:pt idx="7">
                  <c:v>5.7603330000000001</c:v>
                </c:pt>
                <c:pt idx="8">
                  <c:v>3.2594837999999999</c:v>
                </c:pt>
                <c:pt idx="9">
                  <c:v>6.8721166</c:v>
                </c:pt>
                <c:pt idx="10">
                  <c:v>0</c:v>
                </c:pt>
                <c:pt idx="11">
                  <c:v>2.0555506000000001</c:v>
                </c:pt>
                <c:pt idx="12">
                  <c:v>2.0671358</c:v>
                </c:pt>
                <c:pt idx="13">
                  <c:v>3.2295604</c:v>
                </c:pt>
                <c:pt idx="14">
                  <c:v>1.1500224999999999</c:v>
                </c:pt>
                <c:pt idx="15">
                  <c:v>0</c:v>
                </c:pt>
                <c:pt idx="16">
                  <c:v>2.3237037999999899</c:v>
                </c:pt>
                <c:pt idx="17">
                  <c:v>1.7618685000000001</c:v>
                </c:pt>
                <c:pt idx="18">
                  <c:v>1.4074316</c:v>
                </c:pt>
                <c:pt idx="19">
                  <c:v>2.6106400000000001</c:v>
                </c:pt>
                <c:pt idx="20">
                  <c:v>3.3058982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FD-4934-BA20-3A80E9B199D2}"/>
            </c:ext>
          </c:extLst>
        </c:ser>
        <c:ser>
          <c:idx val="1"/>
          <c:order val="1"/>
          <c:tx>
            <c:strRef>
              <c:f>'Selected immune genes II'!$D$65</c:f>
              <c:strCache>
                <c:ptCount val="1"/>
                <c:pt idx="0">
                  <c:v>LOC3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lected immune genes II'!$B$66:$B$86</c:f>
              <c:strCache>
                <c:ptCount val="21"/>
                <c:pt idx="0">
                  <c:v>Cd164</c:v>
                </c:pt>
                <c:pt idx="1">
                  <c:v>Cd200r2</c:v>
                </c:pt>
                <c:pt idx="2">
                  <c:v>Cd200r4</c:v>
                </c:pt>
                <c:pt idx="3">
                  <c:v>Cd209a</c:v>
                </c:pt>
                <c:pt idx="4">
                  <c:v>Cd209b</c:v>
                </c:pt>
                <c:pt idx="5">
                  <c:v>Cd38</c:v>
                </c:pt>
                <c:pt idx="6">
                  <c:v>Cd40</c:v>
                </c:pt>
                <c:pt idx="7">
                  <c:v>Cd69</c:v>
                </c:pt>
                <c:pt idx="8">
                  <c:v>Cd80</c:v>
                </c:pt>
                <c:pt idx="9">
                  <c:v>Cd83</c:v>
                </c:pt>
                <c:pt idx="10">
                  <c:v>Cd86</c:v>
                </c:pt>
                <c:pt idx="11">
                  <c:v>Fcgr1</c:v>
                </c:pt>
                <c:pt idx="12">
                  <c:v>Fcgr4</c:v>
                </c:pt>
                <c:pt idx="13">
                  <c:v>Fcmr</c:v>
                </c:pt>
                <c:pt idx="14">
                  <c:v>H2-K1</c:v>
                </c:pt>
                <c:pt idx="15">
                  <c:v>H2-M3</c:v>
                </c:pt>
                <c:pt idx="16">
                  <c:v>H2-Q10</c:v>
                </c:pt>
                <c:pt idx="17">
                  <c:v>H2-T10</c:v>
                </c:pt>
                <c:pt idx="18">
                  <c:v>H2-T22</c:v>
                </c:pt>
                <c:pt idx="19">
                  <c:v>Siglec1</c:v>
                </c:pt>
                <c:pt idx="20">
                  <c:v>Siglecf</c:v>
                </c:pt>
              </c:strCache>
            </c:strRef>
          </c:cat>
          <c:val>
            <c:numRef>
              <c:f>'Selected immune genes II'!$D$66:$D$86</c:f>
              <c:numCache>
                <c:formatCode>General</c:formatCode>
                <c:ptCount val="21"/>
                <c:pt idx="0">
                  <c:v>0</c:v>
                </c:pt>
                <c:pt idx="1">
                  <c:v>0</c:v>
                </c:pt>
                <c:pt idx="2">
                  <c:v>2.1913670999999999</c:v>
                </c:pt>
                <c:pt idx="3">
                  <c:v>0</c:v>
                </c:pt>
                <c:pt idx="4">
                  <c:v>5.0200589999999998</c:v>
                </c:pt>
                <c:pt idx="5">
                  <c:v>0</c:v>
                </c:pt>
                <c:pt idx="6">
                  <c:v>5.8570557000000001</c:v>
                </c:pt>
                <c:pt idx="7">
                  <c:v>5.7383145999999901</c:v>
                </c:pt>
                <c:pt idx="8">
                  <c:v>4.2383327</c:v>
                </c:pt>
                <c:pt idx="9">
                  <c:v>5.2292480000000001</c:v>
                </c:pt>
                <c:pt idx="10">
                  <c:v>1.3359698999999901</c:v>
                </c:pt>
                <c:pt idx="11">
                  <c:v>2.2353725</c:v>
                </c:pt>
                <c:pt idx="12">
                  <c:v>2.4309006000000002</c:v>
                </c:pt>
                <c:pt idx="13">
                  <c:v>2.1018829999999999</c:v>
                </c:pt>
                <c:pt idx="14">
                  <c:v>1.8150921</c:v>
                </c:pt>
                <c:pt idx="15">
                  <c:v>1.3439808</c:v>
                </c:pt>
                <c:pt idx="16">
                  <c:v>1.5634908999999999</c:v>
                </c:pt>
                <c:pt idx="17">
                  <c:v>2.3427715</c:v>
                </c:pt>
                <c:pt idx="18">
                  <c:v>2.1402245</c:v>
                </c:pt>
                <c:pt idx="19">
                  <c:v>3.2440095000000002</c:v>
                </c:pt>
                <c:pt idx="20">
                  <c:v>2.1489943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EFD-4934-BA20-3A80E9B199D2}"/>
            </c:ext>
          </c:extLst>
        </c:ser>
        <c:ser>
          <c:idx val="2"/>
          <c:order val="2"/>
          <c:tx>
            <c:strRef>
              <c:f>'Selected immune genes II'!$E$65</c:f>
              <c:strCache>
                <c:ptCount val="1"/>
                <c:pt idx="0">
                  <c:v>LOC1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lected immune genes II'!$B$66:$B$86</c:f>
              <c:strCache>
                <c:ptCount val="21"/>
                <c:pt idx="0">
                  <c:v>Cd164</c:v>
                </c:pt>
                <c:pt idx="1">
                  <c:v>Cd200r2</c:v>
                </c:pt>
                <c:pt idx="2">
                  <c:v>Cd200r4</c:v>
                </c:pt>
                <c:pt idx="3">
                  <c:v>Cd209a</c:v>
                </c:pt>
                <c:pt idx="4">
                  <c:v>Cd209b</c:v>
                </c:pt>
                <c:pt idx="5">
                  <c:v>Cd38</c:v>
                </c:pt>
                <c:pt idx="6">
                  <c:v>Cd40</c:v>
                </c:pt>
                <c:pt idx="7">
                  <c:v>Cd69</c:v>
                </c:pt>
                <c:pt idx="8">
                  <c:v>Cd80</c:v>
                </c:pt>
                <c:pt idx="9">
                  <c:v>Cd83</c:v>
                </c:pt>
                <c:pt idx="10">
                  <c:v>Cd86</c:v>
                </c:pt>
                <c:pt idx="11">
                  <c:v>Fcgr1</c:v>
                </c:pt>
                <c:pt idx="12">
                  <c:v>Fcgr4</c:v>
                </c:pt>
                <c:pt idx="13">
                  <c:v>Fcmr</c:v>
                </c:pt>
                <c:pt idx="14">
                  <c:v>H2-K1</c:v>
                </c:pt>
                <c:pt idx="15">
                  <c:v>H2-M3</c:v>
                </c:pt>
                <c:pt idx="16">
                  <c:v>H2-Q10</c:v>
                </c:pt>
                <c:pt idx="17">
                  <c:v>H2-T10</c:v>
                </c:pt>
                <c:pt idx="18">
                  <c:v>H2-T22</c:v>
                </c:pt>
                <c:pt idx="19">
                  <c:v>Siglec1</c:v>
                </c:pt>
                <c:pt idx="20">
                  <c:v>Siglecf</c:v>
                </c:pt>
              </c:strCache>
            </c:strRef>
          </c:cat>
          <c:val>
            <c:numRef>
              <c:f>'Selected immune genes II'!$E$66:$E$86</c:f>
              <c:numCache>
                <c:formatCode>General</c:formatCode>
                <c:ptCount val="21"/>
                <c:pt idx="0">
                  <c:v>1.3742684999999999</c:v>
                </c:pt>
                <c:pt idx="1">
                  <c:v>0</c:v>
                </c:pt>
                <c:pt idx="2">
                  <c:v>1.8228401999999999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5.8325670000000001</c:v>
                </c:pt>
                <c:pt idx="7">
                  <c:v>5.7650193999999999</c:v>
                </c:pt>
                <c:pt idx="8">
                  <c:v>4.1282569999999996</c:v>
                </c:pt>
                <c:pt idx="9">
                  <c:v>5.1633360000000001</c:v>
                </c:pt>
                <c:pt idx="10">
                  <c:v>1.3114986</c:v>
                </c:pt>
                <c:pt idx="11">
                  <c:v>2.1245307999999898</c:v>
                </c:pt>
                <c:pt idx="12">
                  <c:v>2.2470254999999999</c:v>
                </c:pt>
                <c:pt idx="13">
                  <c:v>1.0358953</c:v>
                </c:pt>
                <c:pt idx="14">
                  <c:v>1.8181915</c:v>
                </c:pt>
                <c:pt idx="15">
                  <c:v>1.3982353000000001</c:v>
                </c:pt>
                <c:pt idx="16">
                  <c:v>1.2367010000000001</c:v>
                </c:pt>
                <c:pt idx="17">
                  <c:v>2.4220609999999998</c:v>
                </c:pt>
                <c:pt idx="18">
                  <c:v>2.1445645999999998</c:v>
                </c:pt>
                <c:pt idx="19">
                  <c:v>3.481112</c:v>
                </c:pt>
                <c:pt idx="20">
                  <c:v>2.232524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EFD-4934-BA20-3A80E9B199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0417312"/>
        <c:axId val="180412608"/>
      </c:barChart>
      <c:catAx>
        <c:axId val="180417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AR"/>
          </a:p>
        </c:txPr>
        <c:crossAx val="180412608"/>
        <c:crosses val="autoZero"/>
        <c:auto val="1"/>
        <c:lblAlgn val="ctr"/>
        <c:lblOffset val="100"/>
        <c:noMultiLvlLbl val="0"/>
      </c:catAx>
      <c:valAx>
        <c:axId val="18041260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AR"/>
          </a:p>
        </c:txPr>
        <c:crossAx val="1804173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A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lected immune genes II'!$C$113</c:f>
              <c:strCache>
                <c:ptCount val="1"/>
                <c:pt idx="0">
                  <c:v>LPS</c:v>
                </c:pt>
              </c:strCache>
            </c:strRef>
          </c:tx>
          <c:spPr>
            <a:solidFill>
              <a:srgbClr val="D99694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elected immune genes II'!$B$114:$B$132</c:f>
              <c:strCache>
                <c:ptCount val="19"/>
                <c:pt idx="0">
                  <c:v>Dhx58</c:v>
                </c:pt>
                <c:pt idx="1">
                  <c:v>Ifi209</c:v>
                </c:pt>
                <c:pt idx="2">
                  <c:v>Ifi213</c:v>
                </c:pt>
                <c:pt idx="3">
                  <c:v>Ifit1bl1</c:v>
                </c:pt>
                <c:pt idx="4">
                  <c:v>Ifit3</c:v>
                </c:pt>
                <c:pt idx="5">
                  <c:v>Ifit3b</c:v>
                </c:pt>
                <c:pt idx="6">
                  <c:v>Ifitm7</c:v>
                </c:pt>
                <c:pt idx="7">
                  <c:v>Ifna1</c:v>
                </c:pt>
                <c:pt idx="8">
                  <c:v>Ifna13</c:v>
                </c:pt>
                <c:pt idx="9">
                  <c:v>Ifna14</c:v>
                </c:pt>
                <c:pt idx="10">
                  <c:v>Ifna2</c:v>
                </c:pt>
                <c:pt idx="11">
                  <c:v>Ifna5</c:v>
                </c:pt>
                <c:pt idx="12">
                  <c:v>Ifna7</c:v>
                </c:pt>
                <c:pt idx="13">
                  <c:v>Ifnab</c:v>
                </c:pt>
                <c:pt idx="14">
                  <c:v>Ifnb1</c:v>
                </c:pt>
                <c:pt idx="15">
                  <c:v>Ifrd1</c:v>
                </c:pt>
                <c:pt idx="16">
                  <c:v>Oas1a</c:v>
                </c:pt>
                <c:pt idx="17">
                  <c:v>Oas2</c:v>
                </c:pt>
                <c:pt idx="18">
                  <c:v>Oas3</c:v>
                </c:pt>
              </c:strCache>
            </c:strRef>
          </c:cat>
          <c:val>
            <c:numRef>
              <c:f>'Selected immune genes II'!$C$114:$C$132</c:f>
              <c:numCache>
                <c:formatCode>General</c:formatCode>
                <c:ptCount val="19"/>
                <c:pt idx="0">
                  <c:v>2.7804002999999899</c:v>
                </c:pt>
                <c:pt idx="1">
                  <c:v>7.5502814999999996</c:v>
                </c:pt>
                <c:pt idx="2">
                  <c:v>2.6446285</c:v>
                </c:pt>
                <c:pt idx="3">
                  <c:v>6.5283819999999997</c:v>
                </c:pt>
                <c:pt idx="4">
                  <c:v>9.7035830000000001</c:v>
                </c:pt>
                <c:pt idx="5">
                  <c:v>9.5783319999999996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1.2961296999999901</c:v>
                </c:pt>
                <c:pt idx="13">
                  <c:v>0</c:v>
                </c:pt>
                <c:pt idx="14">
                  <c:v>8.6988070000000004</c:v>
                </c:pt>
                <c:pt idx="15">
                  <c:v>1.1566896</c:v>
                </c:pt>
                <c:pt idx="16">
                  <c:v>2.53062439999999</c:v>
                </c:pt>
                <c:pt idx="17">
                  <c:v>4.6216382999999999</c:v>
                </c:pt>
                <c:pt idx="18">
                  <c:v>3.5295285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47-449D-B307-611BB8759911}"/>
            </c:ext>
          </c:extLst>
        </c:ser>
        <c:ser>
          <c:idx val="1"/>
          <c:order val="1"/>
          <c:tx>
            <c:strRef>
              <c:f>'Selected immune genes II'!$D$113</c:f>
              <c:strCache>
                <c:ptCount val="1"/>
                <c:pt idx="0">
                  <c:v>LOC3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elected immune genes II'!$B$114:$B$132</c:f>
              <c:strCache>
                <c:ptCount val="19"/>
                <c:pt idx="0">
                  <c:v>Dhx58</c:v>
                </c:pt>
                <c:pt idx="1">
                  <c:v>Ifi209</c:v>
                </c:pt>
                <c:pt idx="2">
                  <c:v>Ifi213</c:v>
                </c:pt>
                <c:pt idx="3">
                  <c:v>Ifit1bl1</c:v>
                </c:pt>
                <c:pt idx="4">
                  <c:v>Ifit3</c:v>
                </c:pt>
                <c:pt idx="5">
                  <c:v>Ifit3b</c:v>
                </c:pt>
                <c:pt idx="6">
                  <c:v>Ifitm7</c:v>
                </c:pt>
                <c:pt idx="7">
                  <c:v>Ifna1</c:v>
                </c:pt>
                <c:pt idx="8">
                  <c:v>Ifna13</c:v>
                </c:pt>
                <c:pt idx="9">
                  <c:v>Ifna14</c:v>
                </c:pt>
                <c:pt idx="10">
                  <c:v>Ifna2</c:v>
                </c:pt>
                <c:pt idx="11">
                  <c:v>Ifna5</c:v>
                </c:pt>
                <c:pt idx="12">
                  <c:v>Ifna7</c:v>
                </c:pt>
                <c:pt idx="13">
                  <c:v>Ifnab</c:v>
                </c:pt>
                <c:pt idx="14">
                  <c:v>Ifnb1</c:v>
                </c:pt>
                <c:pt idx="15">
                  <c:v>Ifrd1</c:v>
                </c:pt>
                <c:pt idx="16">
                  <c:v>Oas1a</c:v>
                </c:pt>
                <c:pt idx="17">
                  <c:v>Oas2</c:v>
                </c:pt>
                <c:pt idx="18">
                  <c:v>Oas3</c:v>
                </c:pt>
              </c:strCache>
            </c:strRef>
          </c:cat>
          <c:val>
            <c:numRef>
              <c:f>'Selected immune genes II'!$D$114:$D$132</c:f>
              <c:numCache>
                <c:formatCode>General</c:formatCode>
                <c:ptCount val="19"/>
                <c:pt idx="0">
                  <c:v>3.1234044999999999</c:v>
                </c:pt>
                <c:pt idx="1">
                  <c:v>8.5785260000000001</c:v>
                </c:pt>
                <c:pt idx="2">
                  <c:v>3.837037</c:v>
                </c:pt>
                <c:pt idx="3">
                  <c:v>7.5865119999999999</c:v>
                </c:pt>
                <c:pt idx="4">
                  <c:v>11.032978999999999</c:v>
                </c:pt>
                <c:pt idx="5">
                  <c:v>10.894328</c:v>
                </c:pt>
                <c:pt idx="6">
                  <c:v>1.0735435</c:v>
                </c:pt>
                <c:pt idx="7">
                  <c:v>2.3534354999999998</c:v>
                </c:pt>
                <c:pt idx="8">
                  <c:v>3.8421616999999899</c:v>
                </c:pt>
                <c:pt idx="9">
                  <c:v>2.0517983000000002</c:v>
                </c:pt>
                <c:pt idx="10">
                  <c:v>3.4531507000000001</c:v>
                </c:pt>
                <c:pt idx="11">
                  <c:v>3.4358939999999998</c:v>
                </c:pt>
                <c:pt idx="12">
                  <c:v>4.7796180000000001</c:v>
                </c:pt>
                <c:pt idx="13">
                  <c:v>1.6919346</c:v>
                </c:pt>
                <c:pt idx="14">
                  <c:v>12.696144</c:v>
                </c:pt>
                <c:pt idx="15">
                  <c:v>1.500761</c:v>
                </c:pt>
                <c:pt idx="16">
                  <c:v>3.0074234</c:v>
                </c:pt>
                <c:pt idx="17">
                  <c:v>5.1133309999999996</c:v>
                </c:pt>
                <c:pt idx="18">
                  <c:v>3.949933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947-449D-B307-611BB8759911}"/>
            </c:ext>
          </c:extLst>
        </c:ser>
        <c:ser>
          <c:idx val="2"/>
          <c:order val="2"/>
          <c:tx>
            <c:strRef>
              <c:f>'Selected immune genes II'!$E$113</c:f>
              <c:strCache>
                <c:ptCount val="1"/>
                <c:pt idx="0">
                  <c:v>LOC1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lected immune genes II'!$B$114:$B$132</c:f>
              <c:strCache>
                <c:ptCount val="19"/>
                <c:pt idx="0">
                  <c:v>Dhx58</c:v>
                </c:pt>
                <c:pt idx="1">
                  <c:v>Ifi209</c:v>
                </c:pt>
                <c:pt idx="2">
                  <c:v>Ifi213</c:v>
                </c:pt>
                <c:pt idx="3">
                  <c:v>Ifit1bl1</c:v>
                </c:pt>
                <c:pt idx="4">
                  <c:v>Ifit3</c:v>
                </c:pt>
                <c:pt idx="5">
                  <c:v>Ifit3b</c:v>
                </c:pt>
                <c:pt idx="6">
                  <c:v>Ifitm7</c:v>
                </c:pt>
                <c:pt idx="7">
                  <c:v>Ifna1</c:v>
                </c:pt>
                <c:pt idx="8">
                  <c:v>Ifna13</c:v>
                </c:pt>
                <c:pt idx="9">
                  <c:v>Ifna14</c:v>
                </c:pt>
                <c:pt idx="10">
                  <c:v>Ifna2</c:v>
                </c:pt>
                <c:pt idx="11">
                  <c:v>Ifna5</c:v>
                </c:pt>
                <c:pt idx="12">
                  <c:v>Ifna7</c:v>
                </c:pt>
                <c:pt idx="13">
                  <c:v>Ifnab</c:v>
                </c:pt>
                <c:pt idx="14">
                  <c:v>Ifnb1</c:v>
                </c:pt>
                <c:pt idx="15">
                  <c:v>Ifrd1</c:v>
                </c:pt>
                <c:pt idx="16">
                  <c:v>Oas1a</c:v>
                </c:pt>
                <c:pt idx="17">
                  <c:v>Oas2</c:v>
                </c:pt>
                <c:pt idx="18">
                  <c:v>Oas3</c:v>
                </c:pt>
              </c:strCache>
            </c:strRef>
          </c:cat>
          <c:val>
            <c:numRef>
              <c:f>'Selected immune genes II'!$E$114:$E$132</c:f>
              <c:numCache>
                <c:formatCode>General</c:formatCode>
                <c:ptCount val="19"/>
                <c:pt idx="0">
                  <c:v>3.0119672</c:v>
                </c:pt>
                <c:pt idx="1">
                  <c:v>8.6025399999999994</c:v>
                </c:pt>
                <c:pt idx="2">
                  <c:v>4.2882185000000002</c:v>
                </c:pt>
                <c:pt idx="3">
                  <c:v>7.4772905999999999</c:v>
                </c:pt>
                <c:pt idx="4">
                  <c:v>11.236981999999999</c:v>
                </c:pt>
                <c:pt idx="5">
                  <c:v>11.135114</c:v>
                </c:pt>
                <c:pt idx="6">
                  <c:v>1.1509761999999999</c:v>
                </c:pt>
                <c:pt idx="7">
                  <c:v>3.2723589999999998</c:v>
                </c:pt>
                <c:pt idx="8">
                  <c:v>5.2314720000000001</c:v>
                </c:pt>
                <c:pt idx="9">
                  <c:v>2.9905642999999902</c:v>
                </c:pt>
                <c:pt idx="10">
                  <c:v>4.3529467999999998</c:v>
                </c:pt>
                <c:pt idx="11">
                  <c:v>4.5302579999999999</c:v>
                </c:pt>
                <c:pt idx="12">
                  <c:v>6.1831990000000001</c:v>
                </c:pt>
                <c:pt idx="13">
                  <c:v>2.9482044999999899</c:v>
                </c:pt>
                <c:pt idx="14">
                  <c:v>13.424033999999899</c:v>
                </c:pt>
                <c:pt idx="15">
                  <c:v>1.7092791000000001</c:v>
                </c:pt>
                <c:pt idx="16">
                  <c:v>3.0251674999999998</c:v>
                </c:pt>
                <c:pt idx="17">
                  <c:v>5.2401586</c:v>
                </c:pt>
                <c:pt idx="18">
                  <c:v>4.0004062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947-449D-B307-611BB87599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24332496"/>
        <c:axId val="224336416"/>
      </c:barChart>
      <c:catAx>
        <c:axId val="224332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AR"/>
          </a:p>
        </c:txPr>
        <c:crossAx val="224336416"/>
        <c:crosses val="autoZero"/>
        <c:auto val="1"/>
        <c:lblAlgn val="ctr"/>
        <c:lblOffset val="100"/>
        <c:noMultiLvlLbl val="0"/>
      </c:catAx>
      <c:valAx>
        <c:axId val="22433641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AR"/>
          </a:p>
        </c:txPr>
        <c:crossAx val="224332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A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AR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3C8FE7-E61A-4219-8C48-550CE7F27CEF}" type="datetimeFigureOut">
              <a:rPr lang="es-AR" smtClean="0"/>
              <a:t>09/08/2022</a:t>
            </a:fld>
            <a:endParaRPr lang="es-AR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963738" y="1143000"/>
            <a:ext cx="2930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AR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AR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71DBAC-A5E4-455A-861B-026F546E33BA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5603256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51933" rtl="0" eaLnBrk="1" latinLnBrk="0" hangingPunct="1">
      <a:defRPr sz="724" kern="1200">
        <a:solidFill>
          <a:schemeClr val="tx1"/>
        </a:solidFill>
        <a:latin typeface="+mn-lt"/>
        <a:ea typeface="+mn-ea"/>
        <a:cs typeface="+mn-cs"/>
      </a:defRPr>
    </a:lvl1pPr>
    <a:lvl2pPr marL="275966" algn="l" defTabSz="551933" rtl="0" eaLnBrk="1" latinLnBrk="0" hangingPunct="1">
      <a:defRPr sz="724" kern="1200">
        <a:solidFill>
          <a:schemeClr val="tx1"/>
        </a:solidFill>
        <a:latin typeface="+mn-lt"/>
        <a:ea typeface="+mn-ea"/>
        <a:cs typeface="+mn-cs"/>
      </a:defRPr>
    </a:lvl2pPr>
    <a:lvl3pPr marL="551933" algn="l" defTabSz="551933" rtl="0" eaLnBrk="1" latinLnBrk="0" hangingPunct="1">
      <a:defRPr sz="724" kern="1200">
        <a:solidFill>
          <a:schemeClr val="tx1"/>
        </a:solidFill>
        <a:latin typeface="+mn-lt"/>
        <a:ea typeface="+mn-ea"/>
        <a:cs typeface="+mn-cs"/>
      </a:defRPr>
    </a:lvl3pPr>
    <a:lvl4pPr marL="827899" algn="l" defTabSz="551933" rtl="0" eaLnBrk="1" latinLnBrk="0" hangingPunct="1">
      <a:defRPr sz="724" kern="1200">
        <a:solidFill>
          <a:schemeClr val="tx1"/>
        </a:solidFill>
        <a:latin typeface="+mn-lt"/>
        <a:ea typeface="+mn-ea"/>
        <a:cs typeface="+mn-cs"/>
      </a:defRPr>
    </a:lvl4pPr>
    <a:lvl5pPr marL="1103865" algn="l" defTabSz="551933" rtl="0" eaLnBrk="1" latinLnBrk="0" hangingPunct="1">
      <a:defRPr sz="724" kern="1200">
        <a:solidFill>
          <a:schemeClr val="tx1"/>
        </a:solidFill>
        <a:latin typeface="+mn-lt"/>
        <a:ea typeface="+mn-ea"/>
        <a:cs typeface="+mn-cs"/>
      </a:defRPr>
    </a:lvl5pPr>
    <a:lvl6pPr marL="1379832" algn="l" defTabSz="551933" rtl="0" eaLnBrk="1" latinLnBrk="0" hangingPunct="1">
      <a:defRPr sz="724" kern="1200">
        <a:solidFill>
          <a:schemeClr val="tx1"/>
        </a:solidFill>
        <a:latin typeface="+mn-lt"/>
        <a:ea typeface="+mn-ea"/>
        <a:cs typeface="+mn-cs"/>
      </a:defRPr>
    </a:lvl6pPr>
    <a:lvl7pPr marL="1655798" algn="l" defTabSz="551933" rtl="0" eaLnBrk="1" latinLnBrk="0" hangingPunct="1">
      <a:defRPr sz="724" kern="1200">
        <a:solidFill>
          <a:schemeClr val="tx1"/>
        </a:solidFill>
        <a:latin typeface="+mn-lt"/>
        <a:ea typeface="+mn-ea"/>
        <a:cs typeface="+mn-cs"/>
      </a:defRPr>
    </a:lvl7pPr>
    <a:lvl8pPr marL="1931764" algn="l" defTabSz="551933" rtl="0" eaLnBrk="1" latinLnBrk="0" hangingPunct="1">
      <a:defRPr sz="724" kern="1200">
        <a:solidFill>
          <a:schemeClr val="tx1"/>
        </a:solidFill>
        <a:latin typeface="+mn-lt"/>
        <a:ea typeface="+mn-ea"/>
        <a:cs typeface="+mn-cs"/>
      </a:defRPr>
    </a:lvl8pPr>
    <a:lvl9pPr marL="2207730" algn="l" defTabSz="551933" rtl="0" eaLnBrk="1" latinLnBrk="0" hangingPunct="1">
      <a:defRPr sz="72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963738" y="1143000"/>
            <a:ext cx="2930525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AR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971DBAC-A5E4-455A-861B-026F546E33BA}" type="slidenum">
              <a:rPr lang="es-AR" smtClean="0"/>
              <a:t>1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40054608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5964" y="4473417"/>
            <a:ext cx="11627566" cy="308671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51927" y="8160135"/>
            <a:ext cx="9575641" cy="368005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849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698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547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396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9245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1094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943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4792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AD3F10-6177-4E05-A4B0-1D39F3B08B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FB1A8A7-0630-4B0F-91B4-2ACD1D0A09D5}" type="datetimeFigureOut">
              <a:rPr lang="en-US" altLang="es-AR"/>
              <a:pPr/>
              <a:t>8/9/2022</a:t>
            </a:fld>
            <a:endParaRPr lang="en-US" altLang="es-A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F22F20-2D06-4687-899D-80A844486B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38220F-F914-4400-AC66-2E66373181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DCCD7D6-A927-4FE3-B1A4-EF514409042B}" type="slidenum">
              <a:rPr lang="en-US" altLang="es-AR"/>
              <a:pPr/>
              <a:t>‹Nº›</a:t>
            </a:fld>
            <a:endParaRPr lang="en-US" altLang="es-AR"/>
          </a:p>
        </p:txBody>
      </p:sp>
    </p:spTree>
    <p:extLst>
      <p:ext uri="{BB962C8B-B14F-4D97-AF65-F5344CB8AC3E}">
        <p14:creationId xmlns:p14="http://schemas.microsoft.com/office/powerpoint/2010/main" val="3112166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281F76-11BD-4819-AA25-A91ED10A4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BEFA677-2B52-46F4-8083-0F8FB13984A8}" type="datetimeFigureOut">
              <a:rPr lang="en-US" altLang="es-AR"/>
              <a:pPr/>
              <a:t>8/9/2022</a:t>
            </a:fld>
            <a:endParaRPr lang="en-US" altLang="es-A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A7B0A7-ADBE-4957-A577-864141CF11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547B2B-B6BE-48CA-9195-69C7351FE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4B5B9C9-E0FC-40B7-8427-0C7DB3FD070B}" type="slidenum">
              <a:rPr lang="en-US" altLang="es-AR"/>
              <a:pPr/>
              <a:t>‹Nº›</a:t>
            </a:fld>
            <a:endParaRPr lang="en-US" altLang="es-AR"/>
          </a:p>
        </p:txBody>
      </p:sp>
    </p:spTree>
    <p:extLst>
      <p:ext uri="{BB962C8B-B14F-4D97-AF65-F5344CB8AC3E}">
        <p14:creationId xmlns:p14="http://schemas.microsoft.com/office/powerpoint/2010/main" val="34683223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917633" y="576680"/>
            <a:ext cx="3077885" cy="1228684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3978" y="576680"/>
            <a:ext cx="9005665" cy="1228684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F9727D-469D-4A6C-864F-96005F6FB6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44EDD07-23CF-4F3F-AF92-D89C2A10E186}" type="datetimeFigureOut">
              <a:rPr lang="en-US" altLang="es-AR"/>
              <a:pPr/>
              <a:t>8/9/2022</a:t>
            </a:fld>
            <a:endParaRPr lang="en-US" altLang="es-A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DB0293-7A40-408C-B5D7-0A14C2B57D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C28E9C-7E8A-444F-AE62-193B501917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9044E09-3A3C-4848-9866-4E162450A906}" type="slidenum">
              <a:rPr lang="en-US" altLang="es-AR"/>
              <a:pPr/>
              <a:t>‹Nº›</a:t>
            </a:fld>
            <a:endParaRPr lang="en-US" altLang="es-AR"/>
          </a:p>
        </p:txBody>
      </p:sp>
    </p:spTree>
    <p:extLst>
      <p:ext uri="{BB962C8B-B14F-4D97-AF65-F5344CB8AC3E}">
        <p14:creationId xmlns:p14="http://schemas.microsoft.com/office/powerpoint/2010/main" val="1834007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C4AC6C-54AC-4F3D-AC6C-D42B9A494B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33004FF-B449-40AA-858E-E8B306E78188}" type="datetimeFigureOut">
              <a:rPr lang="en-US" altLang="es-AR"/>
              <a:pPr/>
              <a:t>8/9/2022</a:t>
            </a:fld>
            <a:endParaRPr lang="en-US" altLang="es-A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F04966-63BC-4099-A916-75D6405CA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0ABD2A-B540-463B-80E7-8CA7B98EC5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020AA6A-BE44-4EAF-A3BA-83A245190CAD}" type="slidenum">
              <a:rPr lang="en-US" altLang="es-AR"/>
              <a:pPr/>
              <a:t>‹Nº›</a:t>
            </a:fld>
            <a:endParaRPr lang="en-US" altLang="es-AR"/>
          </a:p>
        </p:txBody>
      </p:sp>
    </p:spTree>
    <p:extLst>
      <p:ext uri="{BB962C8B-B14F-4D97-AF65-F5344CB8AC3E}">
        <p14:creationId xmlns:p14="http://schemas.microsoft.com/office/powerpoint/2010/main" val="24582295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0585" y="9253481"/>
            <a:ext cx="11627566" cy="2860037"/>
          </a:xfrm>
        </p:spPr>
        <p:txBody>
          <a:bodyPr anchor="t"/>
          <a:lstStyle>
            <a:lvl1pPr algn="l">
              <a:defRPr sz="1618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0585" y="6103436"/>
            <a:ext cx="11627566" cy="3150045"/>
          </a:xfrm>
        </p:spPr>
        <p:txBody>
          <a:bodyPr anchor="b"/>
          <a:lstStyle>
            <a:lvl1pPr marL="0" indent="0">
              <a:buNone/>
              <a:defRPr sz="809">
                <a:solidFill>
                  <a:schemeClr val="tx1">
                    <a:tint val="75000"/>
                  </a:schemeClr>
                </a:solidFill>
              </a:defRPr>
            </a:lvl1pPr>
            <a:lvl2pPr marL="184903" indent="0">
              <a:buNone/>
              <a:defRPr sz="729">
                <a:solidFill>
                  <a:schemeClr val="tx1">
                    <a:tint val="75000"/>
                  </a:schemeClr>
                </a:solidFill>
              </a:defRPr>
            </a:lvl2pPr>
            <a:lvl3pPr marL="369806" indent="0">
              <a:buNone/>
              <a:defRPr sz="647">
                <a:solidFill>
                  <a:schemeClr val="tx1">
                    <a:tint val="75000"/>
                  </a:schemeClr>
                </a:solidFill>
              </a:defRPr>
            </a:lvl3pPr>
            <a:lvl4pPr marL="554709" indent="0">
              <a:buNone/>
              <a:defRPr sz="566">
                <a:solidFill>
                  <a:schemeClr val="tx1">
                    <a:tint val="75000"/>
                  </a:schemeClr>
                </a:solidFill>
              </a:defRPr>
            </a:lvl4pPr>
            <a:lvl5pPr marL="739612" indent="0">
              <a:buNone/>
              <a:defRPr sz="566">
                <a:solidFill>
                  <a:schemeClr val="tx1">
                    <a:tint val="75000"/>
                  </a:schemeClr>
                </a:solidFill>
              </a:defRPr>
            </a:lvl5pPr>
            <a:lvl6pPr marL="924515" indent="0">
              <a:buNone/>
              <a:defRPr sz="566">
                <a:solidFill>
                  <a:schemeClr val="tx1">
                    <a:tint val="75000"/>
                  </a:schemeClr>
                </a:solidFill>
              </a:defRPr>
            </a:lvl6pPr>
            <a:lvl7pPr marL="1109419" indent="0">
              <a:buNone/>
              <a:defRPr sz="566">
                <a:solidFill>
                  <a:schemeClr val="tx1">
                    <a:tint val="75000"/>
                  </a:schemeClr>
                </a:solidFill>
              </a:defRPr>
            </a:lvl7pPr>
            <a:lvl8pPr marL="1294321" indent="0">
              <a:buNone/>
              <a:defRPr sz="566">
                <a:solidFill>
                  <a:schemeClr val="tx1">
                    <a:tint val="75000"/>
                  </a:schemeClr>
                </a:solidFill>
              </a:defRPr>
            </a:lvl8pPr>
            <a:lvl9pPr marL="1479226" indent="0">
              <a:buNone/>
              <a:defRPr sz="56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8DA811-4A07-443A-8F4F-C2271DA3A0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E5F785C-FC49-4CF0-8F11-6EE0DE2A650A}" type="datetimeFigureOut">
              <a:rPr lang="en-US" altLang="es-AR"/>
              <a:pPr/>
              <a:t>8/9/2022</a:t>
            </a:fld>
            <a:endParaRPr lang="en-US" altLang="es-A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A994B9-DEA4-4075-9E57-EE3E90ACDD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F5A845-4A4F-461E-90DF-36BC82AFA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D7D2105-7AF5-4675-ADBD-D46B8F5E296F}" type="slidenum">
              <a:rPr lang="en-US" altLang="es-AR"/>
              <a:pPr/>
              <a:t>‹Nº›</a:t>
            </a:fld>
            <a:endParaRPr lang="en-US" altLang="es-AR"/>
          </a:p>
        </p:txBody>
      </p:sp>
    </p:spTree>
    <p:extLst>
      <p:ext uri="{BB962C8B-B14F-4D97-AF65-F5344CB8AC3E}">
        <p14:creationId xmlns:p14="http://schemas.microsoft.com/office/powerpoint/2010/main" val="3219872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3975" y="3360059"/>
            <a:ext cx="6041774" cy="9503477"/>
          </a:xfrm>
        </p:spPr>
        <p:txBody>
          <a:bodyPr/>
          <a:lstStyle>
            <a:lvl1pPr>
              <a:defRPr sz="1133"/>
            </a:lvl1pPr>
            <a:lvl2pPr>
              <a:defRPr sz="971"/>
            </a:lvl2pPr>
            <a:lvl3pPr>
              <a:defRPr sz="809"/>
            </a:lvl3pPr>
            <a:lvl4pPr>
              <a:defRPr sz="729"/>
            </a:lvl4pPr>
            <a:lvl5pPr>
              <a:defRPr sz="729"/>
            </a:lvl5pPr>
            <a:lvl6pPr>
              <a:defRPr sz="729"/>
            </a:lvl6pPr>
            <a:lvl7pPr>
              <a:defRPr sz="729"/>
            </a:lvl7pPr>
            <a:lvl8pPr>
              <a:defRPr sz="729"/>
            </a:lvl8pPr>
            <a:lvl9pPr>
              <a:defRPr sz="72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53744" y="3360059"/>
            <a:ext cx="6041774" cy="9503477"/>
          </a:xfrm>
        </p:spPr>
        <p:txBody>
          <a:bodyPr/>
          <a:lstStyle>
            <a:lvl1pPr>
              <a:defRPr sz="1133"/>
            </a:lvl1pPr>
            <a:lvl2pPr>
              <a:defRPr sz="971"/>
            </a:lvl2pPr>
            <a:lvl3pPr>
              <a:defRPr sz="809"/>
            </a:lvl3pPr>
            <a:lvl4pPr>
              <a:defRPr sz="729"/>
            </a:lvl4pPr>
            <a:lvl5pPr>
              <a:defRPr sz="729"/>
            </a:lvl5pPr>
            <a:lvl6pPr>
              <a:defRPr sz="729"/>
            </a:lvl6pPr>
            <a:lvl7pPr>
              <a:defRPr sz="729"/>
            </a:lvl7pPr>
            <a:lvl8pPr>
              <a:defRPr sz="729"/>
            </a:lvl8pPr>
            <a:lvl9pPr>
              <a:defRPr sz="72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B4939BD7-0F67-4D23-BECB-60D066923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3EF3112-2760-4C14-91CB-C607B31190FC}" type="datetimeFigureOut">
              <a:rPr lang="en-US" altLang="es-AR"/>
              <a:pPr/>
              <a:t>8/9/2022</a:t>
            </a:fld>
            <a:endParaRPr lang="en-US" altLang="es-AR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6A44990F-6C83-47B2-BEB6-9B622253C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D03EE08C-F004-464A-AB8B-9FCB6D8E15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9009F6D-ED67-41A1-A209-DDC0397783E2}" type="slidenum">
              <a:rPr lang="en-US" altLang="es-AR"/>
              <a:pPr/>
              <a:t>‹Nº›</a:t>
            </a:fld>
            <a:endParaRPr lang="en-US" altLang="es-AR"/>
          </a:p>
        </p:txBody>
      </p:sp>
    </p:spTree>
    <p:extLst>
      <p:ext uri="{BB962C8B-B14F-4D97-AF65-F5344CB8AC3E}">
        <p14:creationId xmlns:p14="http://schemas.microsoft.com/office/powerpoint/2010/main" val="527882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3982" y="3223389"/>
            <a:ext cx="6044150" cy="1343356"/>
          </a:xfrm>
        </p:spPr>
        <p:txBody>
          <a:bodyPr anchor="b"/>
          <a:lstStyle>
            <a:lvl1pPr marL="0" indent="0">
              <a:buNone/>
              <a:defRPr sz="971" b="1"/>
            </a:lvl1pPr>
            <a:lvl2pPr marL="184903" indent="0">
              <a:buNone/>
              <a:defRPr sz="809" b="1"/>
            </a:lvl2pPr>
            <a:lvl3pPr marL="369806" indent="0">
              <a:buNone/>
              <a:defRPr sz="729" b="1"/>
            </a:lvl3pPr>
            <a:lvl4pPr marL="554709" indent="0">
              <a:buNone/>
              <a:defRPr sz="647" b="1"/>
            </a:lvl4pPr>
            <a:lvl5pPr marL="739612" indent="0">
              <a:buNone/>
              <a:defRPr sz="647" b="1"/>
            </a:lvl5pPr>
            <a:lvl6pPr marL="924515" indent="0">
              <a:buNone/>
              <a:defRPr sz="647" b="1"/>
            </a:lvl6pPr>
            <a:lvl7pPr marL="1109419" indent="0">
              <a:buNone/>
              <a:defRPr sz="647" b="1"/>
            </a:lvl7pPr>
            <a:lvl8pPr marL="1294321" indent="0">
              <a:buNone/>
              <a:defRPr sz="647" b="1"/>
            </a:lvl8pPr>
            <a:lvl9pPr marL="1479226" indent="0">
              <a:buNone/>
              <a:defRPr sz="64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3982" y="4566751"/>
            <a:ext cx="6044150" cy="8296794"/>
          </a:xfrm>
        </p:spPr>
        <p:txBody>
          <a:bodyPr/>
          <a:lstStyle>
            <a:lvl1pPr>
              <a:defRPr sz="971"/>
            </a:lvl1pPr>
            <a:lvl2pPr>
              <a:defRPr sz="809"/>
            </a:lvl2pPr>
            <a:lvl3pPr>
              <a:defRPr sz="729"/>
            </a:lvl3pPr>
            <a:lvl4pPr>
              <a:defRPr sz="647"/>
            </a:lvl4pPr>
            <a:lvl5pPr>
              <a:defRPr sz="647"/>
            </a:lvl5pPr>
            <a:lvl6pPr>
              <a:defRPr sz="647"/>
            </a:lvl6pPr>
            <a:lvl7pPr>
              <a:defRPr sz="647"/>
            </a:lvl7pPr>
            <a:lvl8pPr>
              <a:defRPr sz="647"/>
            </a:lvl8pPr>
            <a:lvl9pPr>
              <a:defRPr sz="64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8998" y="3223389"/>
            <a:ext cx="6046523" cy="1343356"/>
          </a:xfrm>
        </p:spPr>
        <p:txBody>
          <a:bodyPr anchor="b"/>
          <a:lstStyle>
            <a:lvl1pPr marL="0" indent="0">
              <a:buNone/>
              <a:defRPr sz="971" b="1"/>
            </a:lvl1pPr>
            <a:lvl2pPr marL="184903" indent="0">
              <a:buNone/>
              <a:defRPr sz="809" b="1"/>
            </a:lvl2pPr>
            <a:lvl3pPr marL="369806" indent="0">
              <a:buNone/>
              <a:defRPr sz="729" b="1"/>
            </a:lvl3pPr>
            <a:lvl4pPr marL="554709" indent="0">
              <a:buNone/>
              <a:defRPr sz="647" b="1"/>
            </a:lvl4pPr>
            <a:lvl5pPr marL="739612" indent="0">
              <a:buNone/>
              <a:defRPr sz="647" b="1"/>
            </a:lvl5pPr>
            <a:lvl6pPr marL="924515" indent="0">
              <a:buNone/>
              <a:defRPr sz="647" b="1"/>
            </a:lvl6pPr>
            <a:lvl7pPr marL="1109419" indent="0">
              <a:buNone/>
              <a:defRPr sz="647" b="1"/>
            </a:lvl7pPr>
            <a:lvl8pPr marL="1294321" indent="0">
              <a:buNone/>
              <a:defRPr sz="647" b="1"/>
            </a:lvl8pPr>
            <a:lvl9pPr marL="1479226" indent="0">
              <a:buNone/>
              <a:defRPr sz="64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8998" y="4566751"/>
            <a:ext cx="6046523" cy="8296794"/>
          </a:xfrm>
        </p:spPr>
        <p:txBody>
          <a:bodyPr/>
          <a:lstStyle>
            <a:lvl1pPr>
              <a:defRPr sz="971"/>
            </a:lvl1pPr>
            <a:lvl2pPr>
              <a:defRPr sz="809"/>
            </a:lvl2pPr>
            <a:lvl3pPr>
              <a:defRPr sz="729"/>
            </a:lvl3pPr>
            <a:lvl4pPr>
              <a:defRPr sz="647"/>
            </a:lvl4pPr>
            <a:lvl5pPr>
              <a:defRPr sz="647"/>
            </a:lvl5pPr>
            <a:lvl6pPr>
              <a:defRPr sz="647"/>
            </a:lvl6pPr>
            <a:lvl7pPr>
              <a:defRPr sz="647"/>
            </a:lvl7pPr>
            <a:lvl8pPr>
              <a:defRPr sz="647"/>
            </a:lvl8pPr>
            <a:lvl9pPr>
              <a:defRPr sz="64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A3BE0BE5-11BB-4E3B-938F-708154B51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D5BFACDF-359C-4E8E-ADAA-71221FCF14A7}" type="datetimeFigureOut">
              <a:rPr lang="en-US" altLang="es-AR"/>
              <a:pPr/>
              <a:t>8/9/2022</a:t>
            </a:fld>
            <a:endParaRPr lang="en-US" altLang="es-AR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A7B6056A-3321-4548-8279-0D9C48A180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CBF21056-8163-4232-90D7-F5E24BFC2D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5F36869-D013-49D5-BB3F-4AB8472DAAAF}" type="slidenum">
              <a:rPr lang="en-US" altLang="es-AR"/>
              <a:pPr/>
              <a:t>‹Nº›</a:t>
            </a:fld>
            <a:endParaRPr lang="en-US" altLang="es-AR"/>
          </a:p>
        </p:txBody>
      </p:sp>
    </p:spTree>
    <p:extLst>
      <p:ext uri="{BB962C8B-B14F-4D97-AF65-F5344CB8AC3E}">
        <p14:creationId xmlns:p14="http://schemas.microsoft.com/office/powerpoint/2010/main" val="2164794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10C0E163-B81D-43E5-9C0B-BC82935EF6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405BE1C-D1BE-43DD-BD54-347927E7DC1C}" type="datetimeFigureOut">
              <a:rPr lang="en-US" altLang="es-AR"/>
              <a:pPr/>
              <a:t>8/9/2022</a:t>
            </a:fld>
            <a:endParaRPr lang="en-US" altLang="es-AR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546DAF26-4732-4909-B26F-26F443CAA2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29CD62D0-A8E0-49AB-B822-50F8253E9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B693C57-493A-4029-B9B6-2617C0840B2B}" type="slidenum">
              <a:rPr lang="en-US" altLang="es-AR"/>
              <a:pPr/>
              <a:t>‹Nº›</a:t>
            </a:fld>
            <a:endParaRPr lang="en-US" altLang="es-AR"/>
          </a:p>
        </p:txBody>
      </p:sp>
    </p:spTree>
    <p:extLst>
      <p:ext uri="{BB962C8B-B14F-4D97-AF65-F5344CB8AC3E}">
        <p14:creationId xmlns:p14="http://schemas.microsoft.com/office/powerpoint/2010/main" val="17056182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720C177B-727B-45ED-8C69-7D0D9420C1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3506097F-E77B-4911-9E48-B55307776B8D}" type="datetimeFigureOut">
              <a:rPr lang="en-US" altLang="es-AR"/>
              <a:pPr/>
              <a:t>8/9/2022</a:t>
            </a:fld>
            <a:endParaRPr lang="en-US" altLang="es-AR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390DC8F1-2390-4ABB-B3AA-0A38850C4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2CD3CDDB-32B9-4213-A811-79981B0098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63F16EB-DCF0-4FBC-8580-99DBB00411AF}" type="slidenum">
              <a:rPr lang="en-US" altLang="es-AR"/>
              <a:pPr/>
              <a:t>‹Nº›</a:t>
            </a:fld>
            <a:endParaRPr lang="en-US" altLang="es-AR"/>
          </a:p>
        </p:txBody>
      </p:sp>
    </p:spTree>
    <p:extLst>
      <p:ext uri="{BB962C8B-B14F-4D97-AF65-F5344CB8AC3E}">
        <p14:creationId xmlns:p14="http://schemas.microsoft.com/office/powerpoint/2010/main" val="15905806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3986" y="573358"/>
            <a:ext cx="4500457" cy="2440035"/>
          </a:xfrm>
        </p:spPr>
        <p:txBody>
          <a:bodyPr anchor="b"/>
          <a:lstStyle>
            <a:lvl1pPr algn="l">
              <a:defRPr sz="809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48304" y="573357"/>
            <a:ext cx="7647213" cy="12290182"/>
          </a:xfrm>
        </p:spPr>
        <p:txBody>
          <a:bodyPr/>
          <a:lstStyle>
            <a:lvl1pPr>
              <a:defRPr sz="1295"/>
            </a:lvl1pPr>
            <a:lvl2pPr>
              <a:defRPr sz="1133"/>
            </a:lvl2pPr>
            <a:lvl3pPr>
              <a:defRPr sz="971"/>
            </a:lvl3pPr>
            <a:lvl4pPr>
              <a:defRPr sz="809"/>
            </a:lvl4pPr>
            <a:lvl5pPr>
              <a:defRPr sz="809"/>
            </a:lvl5pPr>
            <a:lvl6pPr>
              <a:defRPr sz="809"/>
            </a:lvl6pPr>
            <a:lvl7pPr>
              <a:defRPr sz="809"/>
            </a:lvl7pPr>
            <a:lvl8pPr>
              <a:defRPr sz="809"/>
            </a:lvl8pPr>
            <a:lvl9pPr>
              <a:defRPr sz="80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3986" y="3013380"/>
            <a:ext cx="4500457" cy="9850146"/>
          </a:xfrm>
        </p:spPr>
        <p:txBody>
          <a:bodyPr/>
          <a:lstStyle>
            <a:lvl1pPr marL="0" indent="0">
              <a:buNone/>
              <a:defRPr sz="566"/>
            </a:lvl1pPr>
            <a:lvl2pPr marL="184903" indent="0">
              <a:buNone/>
              <a:defRPr sz="485"/>
            </a:lvl2pPr>
            <a:lvl3pPr marL="369806" indent="0">
              <a:buNone/>
              <a:defRPr sz="405"/>
            </a:lvl3pPr>
            <a:lvl4pPr marL="554709" indent="0">
              <a:buNone/>
              <a:defRPr sz="364"/>
            </a:lvl4pPr>
            <a:lvl5pPr marL="739612" indent="0">
              <a:buNone/>
              <a:defRPr sz="364"/>
            </a:lvl5pPr>
            <a:lvl6pPr marL="924515" indent="0">
              <a:buNone/>
              <a:defRPr sz="364"/>
            </a:lvl6pPr>
            <a:lvl7pPr marL="1109419" indent="0">
              <a:buNone/>
              <a:defRPr sz="364"/>
            </a:lvl7pPr>
            <a:lvl8pPr marL="1294321" indent="0">
              <a:buNone/>
              <a:defRPr sz="364"/>
            </a:lvl8pPr>
            <a:lvl9pPr marL="1479226" indent="0">
              <a:buNone/>
              <a:defRPr sz="36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9EB0B099-1A33-4286-97D9-FB27221C2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0B6F412-25B4-4723-AC9A-9437ED34938D}" type="datetimeFigureOut">
              <a:rPr lang="en-US" altLang="es-AR"/>
              <a:pPr/>
              <a:t>8/9/2022</a:t>
            </a:fld>
            <a:endParaRPr lang="en-US" altLang="es-AR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A9AAFEED-883D-4A2F-A6A6-1A8982D222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D5F4BD5D-018D-474B-AEE2-97FC0960F3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F756EAC-DDB7-45C1-9884-54422621FFB3}" type="slidenum">
              <a:rPr lang="en-US" altLang="es-AR"/>
              <a:pPr/>
              <a:t>‹Nº›</a:t>
            </a:fld>
            <a:endParaRPr lang="en-US" altLang="es-AR"/>
          </a:p>
        </p:txBody>
      </p:sp>
    </p:spTree>
    <p:extLst>
      <p:ext uri="{BB962C8B-B14F-4D97-AF65-F5344CB8AC3E}">
        <p14:creationId xmlns:p14="http://schemas.microsoft.com/office/powerpoint/2010/main" val="34840944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81279" y="10080160"/>
            <a:ext cx="8207693" cy="1190017"/>
          </a:xfrm>
        </p:spPr>
        <p:txBody>
          <a:bodyPr anchor="b"/>
          <a:lstStyle>
            <a:lvl1pPr algn="l">
              <a:defRPr sz="809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681279" y="1286694"/>
            <a:ext cx="8207693" cy="8640128"/>
          </a:xfrm>
        </p:spPr>
        <p:txBody>
          <a:bodyPr rtlCol="0">
            <a:normAutofit/>
          </a:bodyPr>
          <a:lstStyle>
            <a:lvl1pPr marL="0" indent="0">
              <a:buNone/>
              <a:defRPr sz="1295"/>
            </a:lvl1pPr>
            <a:lvl2pPr marL="184903" indent="0">
              <a:buNone/>
              <a:defRPr sz="1133"/>
            </a:lvl2pPr>
            <a:lvl3pPr marL="369806" indent="0">
              <a:buNone/>
              <a:defRPr sz="971"/>
            </a:lvl3pPr>
            <a:lvl4pPr marL="554709" indent="0">
              <a:buNone/>
              <a:defRPr sz="809"/>
            </a:lvl4pPr>
            <a:lvl5pPr marL="739612" indent="0">
              <a:buNone/>
              <a:defRPr sz="809"/>
            </a:lvl5pPr>
            <a:lvl6pPr marL="924515" indent="0">
              <a:buNone/>
              <a:defRPr sz="809"/>
            </a:lvl6pPr>
            <a:lvl7pPr marL="1109419" indent="0">
              <a:buNone/>
              <a:defRPr sz="809"/>
            </a:lvl7pPr>
            <a:lvl8pPr marL="1294321" indent="0">
              <a:buNone/>
              <a:defRPr sz="809"/>
            </a:lvl8pPr>
            <a:lvl9pPr marL="1479226" indent="0">
              <a:buNone/>
              <a:defRPr sz="809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681279" y="11270170"/>
            <a:ext cx="8207693" cy="1690022"/>
          </a:xfrm>
        </p:spPr>
        <p:txBody>
          <a:bodyPr/>
          <a:lstStyle>
            <a:lvl1pPr marL="0" indent="0">
              <a:buNone/>
              <a:defRPr sz="566"/>
            </a:lvl1pPr>
            <a:lvl2pPr marL="184903" indent="0">
              <a:buNone/>
              <a:defRPr sz="485"/>
            </a:lvl2pPr>
            <a:lvl3pPr marL="369806" indent="0">
              <a:buNone/>
              <a:defRPr sz="405"/>
            </a:lvl3pPr>
            <a:lvl4pPr marL="554709" indent="0">
              <a:buNone/>
              <a:defRPr sz="364"/>
            </a:lvl4pPr>
            <a:lvl5pPr marL="739612" indent="0">
              <a:buNone/>
              <a:defRPr sz="364"/>
            </a:lvl5pPr>
            <a:lvl6pPr marL="924515" indent="0">
              <a:buNone/>
              <a:defRPr sz="364"/>
            </a:lvl6pPr>
            <a:lvl7pPr marL="1109419" indent="0">
              <a:buNone/>
              <a:defRPr sz="364"/>
            </a:lvl7pPr>
            <a:lvl8pPr marL="1294321" indent="0">
              <a:buNone/>
              <a:defRPr sz="364"/>
            </a:lvl8pPr>
            <a:lvl9pPr marL="1479226" indent="0">
              <a:buNone/>
              <a:defRPr sz="36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575B7AA9-523B-4285-9CCF-72321C742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3570F2A6-82A8-4A90-A77A-0B26825808E8}" type="datetimeFigureOut">
              <a:rPr lang="en-US" altLang="es-AR"/>
              <a:pPr/>
              <a:t>8/9/2022</a:t>
            </a:fld>
            <a:endParaRPr lang="en-US" altLang="es-AR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EC7D3D65-FCE1-470F-BD04-D5363A248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7F9B2AB9-3558-4D4B-BBF4-86E1F61354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0B234BB-BC95-4719-90E0-1E9E58F85F97}" type="slidenum">
              <a:rPr lang="en-US" altLang="es-AR"/>
              <a:pPr/>
              <a:t>‹Nº›</a:t>
            </a:fld>
            <a:endParaRPr lang="en-US" altLang="es-AR"/>
          </a:p>
        </p:txBody>
      </p:sp>
    </p:spTree>
    <p:extLst>
      <p:ext uri="{BB962C8B-B14F-4D97-AF65-F5344CB8AC3E}">
        <p14:creationId xmlns:p14="http://schemas.microsoft.com/office/powerpoint/2010/main" val="18535646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2CA18F45-6136-41ED-9179-93545E42736B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683979" y="576687"/>
            <a:ext cx="12311540" cy="24000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s-AR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25E14B5E-E226-4E6C-81EE-6A9BD45C49E8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83979" y="3360059"/>
            <a:ext cx="12311540" cy="95034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s-AR"/>
              <a:t>Click to edit Master text styles</a:t>
            </a:r>
          </a:p>
          <a:p>
            <a:pPr lvl="1"/>
            <a:r>
              <a:rPr lang="en-US" altLang="es-AR"/>
              <a:t>Second level</a:t>
            </a:r>
          </a:p>
          <a:p>
            <a:pPr lvl="2"/>
            <a:r>
              <a:rPr lang="en-US" altLang="es-AR"/>
              <a:t>Third level</a:t>
            </a:r>
          </a:p>
          <a:p>
            <a:pPr lvl="3"/>
            <a:r>
              <a:rPr lang="en-US" altLang="es-AR"/>
              <a:t>Fourth level</a:t>
            </a:r>
          </a:p>
          <a:p>
            <a:pPr lvl="4"/>
            <a:r>
              <a:rPr lang="en-US" altLang="es-AR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D21926-D9C1-4481-83D1-98FD84FD2D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83979" y="13346875"/>
            <a:ext cx="3191882" cy="76668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485">
                <a:solidFill>
                  <a:srgbClr val="898989"/>
                </a:solidFill>
              </a:defRPr>
            </a:lvl1pPr>
          </a:lstStyle>
          <a:p>
            <a:fld id="{5913451C-79E4-4C45-BE4E-2460A6D492F7}" type="datetimeFigureOut">
              <a:rPr lang="en-US" altLang="es-AR"/>
              <a:pPr/>
              <a:t>8/9/2022</a:t>
            </a:fld>
            <a:endParaRPr lang="en-US" altLang="es-A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06739D-72C3-4634-B836-85C75B29812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673826" y="13346875"/>
            <a:ext cx="4331838" cy="7666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485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8D9633-E11E-4F75-B1ED-C7ECC98171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9803638" y="13346875"/>
            <a:ext cx="3191882" cy="76668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485">
                <a:solidFill>
                  <a:srgbClr val="898989"/>
                </a:solidFill>
              </a:defRPr>
            </a:lvl1pPr>
          </a:lstStyle>
          <a:p>
            <a:fld id="{87C5E69E-DBEF-4967-9189-04EC56F1E43B}" type="slidenum">
              <a:rPr lang="en-US" altLang="es-AR"/>
              <a:pPr/>
              <a:t>‹Nº›</a:t>
            </a:fld>
            <a:endParaRPr lang="en-US" altLang="es-A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84903" rtl="0" eaLnBrk="0" fontAlgn="base" hangingPunct="0">
        <a:spcBef>
          <a:spcPct val="0"/>
        </a:spcBef>
        <a:spcAft>
          <a:spcPct val="0"/>
        </a:spcAft>
        <a:defRPr sz="1779" kern="1200">
          <a:solidFill>
            <a:schemeClr val="tx1"/>
          </a:solidFill>
          <a:latin typeface="+mj-lt"/>
          <a:ea typeface="MS PGothic" panose="020B0600070205080204" pitchFamily="34" charset="-128"/>
          <a:cs typeface="ＭＳ Ｐゴシック" charset="0"/>
        </a:defRPr>
      </a:lvl1pPr>
      <a:lvl2pPr algn="ctr" defTabSz="184903" rtl="0" eaLnBrk="0" fontAlgn="base" hangingPunct="0">
        <a:spcBef>
          <a:spcPct val="0"/>
        </a:spcBef>
        <a:spcAft>
          <a:spcPct val="0"/>
        </a:spcAft>
        <a:defRPr sz="1779">
          <a:solidFill>
            <a:schemeClr val="tx1"/>
          </a:solidFill>
          <a:latin typeface="Calibri" charset="0"/>
          <a:ea typeface="MS PGothic" panose="020B0600070205080204" pitchFamily="34" charset="-128"/>
          <a:cs typeface="ＭＳ Ｐゴシック" charset="0"/>
        </a:defRPr>
      </a:lvl2pPr>
      <a:lvl3pPr algn="ctr" defTabSz="184903" rtl="0" eaLnBrk="0" fontAlgn="base" hangingPunct="0">
        <a:spcBef>
          <a:spcPct val="0"/>
        </a:spcBef>
        <a:spcAft>
          <a:spcPct val="0"/>
        </a:spcAft>
        <a:defRPr sz="1779">
          <a:solidFill>
            <a:schemeClr val="tx1"/>
          </a:solidFill>
          <a:latin typeface="Calibri" charset="0"/>
          <a:ea typeface="MS PGothic" panose="020B0600070205080204" pitchFamily="34" charset="-128"/>
          <a:cs typeface="ＭＳ Ｐゴシック" charset="0"/>
        </a:defRPr>
      </a:lvl3pPr>
      <a:lvl4pPr algn="ctr" defTabSz="184903" rtl="0" eaLnBrk="0" fontAlgn="base" hangingPunct="0">
        <a:spcBef>
          <a:spcPct val="0"/>
        </a:spcBef>
        <a:spcAft>
          <a:spcPct val="0"/>
        </a:spcAft>
        <a:defRPr sz="1779">
          <a:solidFill>
            <a:schemeClr val="tx1"/>
          </a:solidFill>
          <a:latin typeface="Calibri" charset="0"/>
          <a:ea typeface="MS PGothic" panose="020B0600070205080204" pitchFamily="34" charset="-128"/>
          <a:cs typeface="ＭＳ Ｐゴシック" charset="0"/>
        </a:defRPr>
      </a:lvl4pPr>
      <a:lvl5pPr algn="ctr" defTabSz="184903" rtl="0" eaLnBrk="0" fontAlgn="base" hangingPunct="0">
        <a:spcBef>
          <a:spcPct val="0"/>
        </a:spcBef>
        <a:spcAft>
          <a:spcPct val="0"/>
        </a:spcAft>
        <a:defRPr sz="1779">
          <a:solidFill>
            <a:schemeClr val="tx1"/>
          </a:solidFill>
          <a:latin typeface="Calibri" charset="0"/>
          <a:ea typeface="MS PGothic" panose="020B0600070205080204" pitchFamily="34" charset="-128"/>
          <a:cs typeface="ＭＳ Ｐゴシック" charset="0"/>
        </a:defRPr>
      </a:lvl5pPr>
      <a:lvl6pPr marL="184903" algn="ctr" defTabSz="184903" rtl="0" fontAlgn="base">
        <a:spcBef>
          <a:spcPct val="0"/>
        </a:spcBef>
        <a:spcAft>
          <a:spcPct val="0"/>
        </a:spcAft>
        <a:defRPr sz="1779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6pPr>
      <a:lvl7pPr marL="369806" algn="ctr" defTabSz="184903" rtl="0" fontAlgn="base">
        <a:spcBef>
          <a:spcPct val="0"/>
        </a:spcBef>
        <a:spcAft>
          <a:spcPct val="0"/>
        </a:spcAft>
        <a:defRPr sz="1779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7pPr>
      <a:lvl8pPr marL="554709" algn="ctr" defTabSz="184903" rtl="0" fontAlgn="base">
        <a:spcBef>
          <a:spcPct val="0"/>
        </a:spcBef>
        <a:spcAft>
          <a:spcPct val="0"/>
        </a:spcAft>
        <a:defRPr sz="1779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8pPr>
      <a:lvl9pPr marL="739612" algn="ctr" defTabSz="184903" rtl="0" fontAlgn="base">
        <a:spcBef>
          <a:spcPct val="0"/>
        </a:spcBef>
        <a:spcAft>
          <a:spcPct val="0"/>
        </a:spcAft>
        <a:defRPr sz="1779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9pPr>
    </p:titleStyle>
    <p:bodyStyle>
      <a:lvl1pPr marL="138678" indent="-138678" algn="l" defTabSz="184903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1295" kern="1200">
          <a:solidFill>
            <a:schemeClr val="tx1"/>
          </a:solidFill>
          <a:latin typeface="+mn-lt"/>
          <a:ea typeface="MS PGothic" panose="020B0600070205080204" pitchFamily="34" charset="-128"/>
          <a:cs typeface="ＭＳ Ｐゴシック" charset="0"/>
        </a:defRPr>
      </a:lvl1pPr>
      <a:lvl2pPr marL="300468" indent="-115565" algn="l" defTabSz="184903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1133" kern="1200">
          <a:solidFill>
            <a:schemeClr val="tx1"/>
          </a:solidFill>
          <a:latin typeface="+mn-lt"/>
          <a:ea typeface="MS PGothic" panose="020B0600070205080204" pitchFamily="34" charset="-128"/>
          <a:cs typeface="+mn-cs"/>
        </a:defRPr>
      </a:lvl2pPr>
      <a:lvl3pPr marL="462257" indent="-92452" algn="l" defTabSz="184903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971" kern="1200">
          <a:solidFill>
            <a:schemeClr val="tx1"/>
          </a:solidFill>
          <a:latin typeface="+mn-lt"/>
          <a:ea typeface="MS PGothic" panose="020B0600070205080204" pitchFamily="34" charset="-128"/>
          <a:cs typeface="+mn-cs"/>
        </a:defRPr>
      </a:lvl3pPr>
      <a:lvl4pPr marL="647161" indent="-92452" algn="l" defTabSz="184903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809" kern="1200">
          <a:solidFill>
            <a:schemeClr val="tx1"/>
          </a:solidFill>
          <a:latin typeface="+mn-lt"/>
          <a:ea typeface="MS PGothic" panose="020B0600070205080204" pitchFamily="34" charset="-128"/>
          <a:cs typeface="+mn-cs"/>
        </a:defRPr>
      </a:lvl4pPr>
      <a:lvl5pPr marL="832063" indent="-92452" algn="l" defTabSz="184903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809" kern="1200">
          <a:solidFill>
            <a:schemeClr val="tx1"/>
          </a:solidFill>
          <a:latin typeface="+mn-lt"/>
          <a:ea typeface="MS PGothic" panose="020B0600070205080204" pitchFamily="34" charset="-128"/>
          <a:cs typeface="+mn-cs"/>
        </a:defRPr>
      </a:lvl5pPr>
      <a:lvl6pPr marL="1016966" indent="-92452" algn="l" defTabSz="184903" rtl="0" eaLnBrk="1" latinLnBrk="0" hangingPunct="1">
        <a:spcBef>
          <a:spcPct val="20000"/>
        </a:spcBef>
        <a:buFont typeface="Arial"/>
        <a:buChar char="•"/>
        <a:defRPr sz="809" kern="1200">
          <a:solidFill>
            <a:schemeClr val="tx1"/>
          </a:solidFill>
          <a:latin typeface="+mn-lt"/>
          <a:ea typeface="+mn-ea"/>
          <a:cs typeface="+mn-cs"/>
        </a:defRPr>
      </a:lvl6pPr>
      <a:lvl7pPr marL="1201870" indent="-92452" algn="l" defTabSz="184903" rtl="0" eaLnBrk="1" latinLnBrk="0" hangingPunct="1">
        <a:spcBef>
          <a:spcPct val="20000"/>
        </a:spcBef>
        <a:buFont typeface="Arial"/>
        <a:buChar char="•"/>
        <a:defRPr sz="809" kern="1200">
          <a:solidFill>
            <a:schemeClr val="tx1"/>
          </a:solidFill>
          <a:latin typeface="+mn-lt"/>
          <a:ea typeface="+mn-ea"/>
          <a:cs typeface="+mn-cs"/>
        </a:defRPr>
      </a:lvl7pPr>
      <a:lvl8pPr marL="1386773" indent="-92452" algn="l" defTabSz="184903" rtl="0" eaLnBrk="1" latinLnBrk="0" hangingPunct="1">
        <a:spcBef>
          <a:spcPct val="20000"/>
        </a:spcBef>
        <a:buFont typeface="Arial"/>
        <a:buChar char="•"/>
        <a:defRPr sz="809" kern="1200">
          <a:solidFill>
            <a:schemeClr val="tx1"/>
          </a:solidFill>
          <a:latin typeface="+mn-lt"/>
          <a:ea typeface="+mn-ea"/>
          <a:cs typeface="+mn-cs"/>
        </a:defRPr>
      </a:lvl8pPr>
      <a:lvl9pPr marL="1571677" indent="-92452" algn="l" defTabSz="184903" rtl="0" eaLnBrk="1" latinLnBrk="0" hangingPunct="1">
        <a:spcBef>
          <a:spcPct val="20000"/>
        </a:spcBef>
        <a:buFont typeface="Arial"/>
        <a:buChar char="•"/>
        <a:defRPr sz="80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4903" rtl="0" eaLnBrk="1" latinLnBrk="0" hangingPunct="1">
        <a:defRPr sz="729" kern="1200">
          <a:solidFill>
            <a:schemeClr val="tx1"/>
          </a:solidFill>
          <a:latin typeface="+mn-lt"/>
          <a:ea typeface="+mn-ea"/>
          <a:cs typeface="+mn-cs"/>
        </a:defRPr>
      </a:lvl1pPr>
      <a:lvl2pPr marL="184903" algn="l" defTabSz="184903" rtl="0" eaLnBrk="1" latinLnBrk="0" hangingPunct="1">
        <a:defRPr sz="729" kern="1200">
          <a:solidFill>
            <a:schemeClr val="tx1"/>
          </a:solidFill>
          <a:latin typeface="+mn-lt"/>
          <a:ea typeface="+mn-ea"/>
          <a:cs typeface="+mn-cs"/>
        </a:defRPr>
      </a:lvl2pPr>
      <a:lvl3pPr marL="369806" algn="l" defTabSz="184903" rtl="0" eaLnBrk="1" latinLnBrk="0" hangingPunct="1">
        <a:defRPr sz="729" kern="1200">
          <a:solidFill>
            <a:schemeClr val="tx1"/>
          </a:solidFill>
          <a:latin typeface="+mn-lt"/>
          <a:ea typeface="+mn-ea"/>
          <a:cs typeface="+mn-cs"/>
        </a:defRPr>
      </a:lvl3pPr>
      <a:lvl4pPr marL="554709" algn="l" defTabSz="184903" rtl="0" eaLnBrk="1" latinLnBrk="0" hangingPunct="1">
        <a:defRPr sz="729" kern="1200">
          <a:solidFill>
            <a:schemeClr val="tx1"/>
          </a:solidFill>
          <a:latin typeface="+mn-lt"/>
          <a:ea typeface="+mn-ea"/>
          <a:cs typeface="+mn-cs"/>
        </a:defRPr>
      </a:lvl4pPr>
      <a:lvl5pPr marL="739612" algn="l" defTabSz="184903" rtl="0" eaLnBrk="1" latinLnBrk="0" hangingPunct="1">
        <a:defRPr sz="729" kern="1200">
          <a:solidFill>
            <a:schemeClr val="tx1"/>
          </a:solidFill>
          <a:latin typeface="+mn-lt"/>
          <a:ea typeface="+mn-ea"/>
          <a:cs typeface="+mn-cs"/>
        </a:defRPr>
      </a:lvl5pPr>
      <a:lvl6pPr marL="924515" algn="l" defTabSz="184903" rtl="0" eaLnBrk="1" latinLnBrk="0" hangingPunct="1">
        <a:defRPr sz="729" kern="1200">
          <a:solidFill>
            <a:schemeClr val="tx1"/>
          </a:solidFill>
          <a:latin typeface="+mn-lt"/>
          <a:ea typeface="+mn-ea"/>
          <a:cs typeface="+mn-cs"/>
        </a:defRPr>
      </a:lvl6pPr>
      <a:lvl7pPr marL="1109419" algn="l" defTabSz="184903" rtl="0" eaLnBrk="1" latinLnBrk="0" hangingPunct="1">
        <a:defRPr sz="729" kern="1200">
          <a:solidFill>
            <a:schemeClr val="tx1"/>
          </a:solidFill>
          <a:latin typeface="+mn-lt"/>
          <a:ea typeface="+mn-ea"/>
          <a:cs typeface="+mn-cs"/>
        </a:defRPr>
      </a:lvl7pPr>
      <a:lvl8pPr marL="1294321" algn="l" defTabSz="184903" rtl="0" eaLnBrk="1" latinLnBrk="0" hangingPunct="1">
        <a:defRPr sz="729" kern="1200">
          <a:solidFill>
            <a:schemeClr val="tx1"/>
          </a:solidFill>
          <a:latin typeface="+mn-lt"/>
          <a:ea typeface="+mn-ea"/>
          <a:cs typeface="+mn-cs"/>
        </a:defRPr>
      </a:lvl8pPr>
      <a:lvl9pPr marL="1479226" algn="l" defTabSz="184903" rtl="0" eaLnBrk="1" latinLnBrk="0" hangingPunct="1">
        <a:defRPr sz="72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3" Type="http://schemas.openxmlformats.org/officeDocument/2006/relationships/image" Target="../media/image1.tiff"/><Relationship Id="rId7" Type="http://schemas.openxmlformats.org/officeDocument/2006/relationships/image" Target="../media/image4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Imagen 21" descr="Imagen que contiene captura de pantalla&#10;&#10;Descripción generada automáticamente">
            <a:extLst>
              <a:ext uri="{FF2B5EF4-FFF2-40B4-BE49-F238E27FC236}">
                <a16:creationId xmlns:a16="http://schemas.microsoft.com/office/drawing/2014/main" id="{D3FAC267-ACC1-E830-83A6-68F36458E65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65"/>
          <a:stretch/>
        </p:blipFill>
        <p:spPr>
          <a:xfrm rot="16200000">
            <a:off x="6230879" y="-976834"/>
            <a:ext cx="1859464" cy="6858000"/>
          </a:xfrm>
          <a:prstGeom prst="rect">
            <a:avLst/>
          </a:prstGeom>
        </p:spPr>
      </p:pic>
      <p:graphicFrame>
        <p:nvGraphicFramePr>
          <p:cNvPr id="23" name="Tabla 8">
            <a:extLst>
              <a:ext uri="{FF2B5EF4-FFF2-40B4-BE49-F238E27FC236}">
                <a16:creationId xmlns:a16="http://schemas.microsoft.com/office/drawing/2014/main" id="{78D940C9-AF47-225D-8712-18A734182E5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5007717"/>
              </p:ext>
            </p:extLst>
          </p:nvPr>
        </p:nvGraphicFramePr>
        <p:xfrm>
          <a:off x="2466203" y="1593959"/>
          <a:ext cx="843920" cy="338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5490">
                  <a:extLst>
                    <a:ext uri="{9D8B030D-6E8A-4147-A177-3AD203B41FA5}">
                      <a16:colId xmlns:a16="http://schemas.microsoft.com/office/drawing/2014/main" val="1985867780"/>
                    </a:ext>
                  </a:extLst>
                </a:gridCol>
                <a:gridCol w="105490">
                  <a:extLst>
                    <a:ext uri="{9D8B030D-6E8A-4147-A177-3AD203B41FA5}">
                      <a16:colId xmlns:a16="http://schemas.microsoft.com/office/drawing/2014/main" val="2414839923"/>
                    </a:ext>
                  </a:extLst>
                </a:gridCol>
                <a:gridCol w="105490">
                  <a:extLst>
                    <a:ext uri="{9D8B030D-6E8A-4147-A177-3AD203B41FA5}">
                      <a16:colId xmlns:a16="http://schemas.microsoft.com/office/drawing/2014/main" val="1152800066"/>
                    </a:ext>
                  </a:extLst>
                </a:gridCol>
                <a:gridCol w="105490">
                  <a:extLst>
                    <a:ext uri="{9D8B030D-6E8A-4147-A177-3AD203B41FA5}">
                      <a16:colId xmlns:a16="http://schemas.microsoft.com/office/drawing/2014/main" val="958640047"/>
                    </a:ext>
                  </a:extLst>
                </a:gridCol>
                <a:gridCol w="105490">
                  <a:extLst>
                    <a:ext uri="{9D8B030D-6E8A-4147-A177-3AD203B41FA5}">
                      <a16:colId xmlns:a16="http://schemas.microsoft.com/office/drawing/2014/main" val="1818967799"/>
                    </a:ext>
                  </a:extLst>
                </a:gridCol>
                <a:gridCol w="105490">
                  <a:extLst>
                    <a:ext uri="{9D8B030D-6E8A-4147-A177-3AD203B41FA5}">
                      <a16:colId xmlns:a16="http://schemas.microsoft.com/office/drawing/2014/main" val="977473853"/>
                    </a:ext>
                  </a:extLst>
                </a:gridCol>
                <a:gridCol w="105490">
                  <a:extLst>
                    <a:ext uri="{9D8B030D-6E8A-4147-A177-3AD203B41FA5}">
                      <a16:colId xmlns:a16="http://schemas.microsoft.com/office/drawing/2014/main" val="1404427292"/>
                    </a:ext>
                  </a:extLst>
                </a:gridCol>
                <a:gridCol w="105490">
                  <a:extLst>
                    <a:ext uri="{9D8B030D-6E8A-4147-A177-3AD203B41FA5}">
                      <a16:colId xmlns:a16="http://schemas.microsoft.com/office/drawing/2014/main" val="1929408398"/>
                    </a:ext>
                  </a:extLst>
                </a:gridCol>
              </a:tblGrid>
              <a:tr h="338554">
                <a:tc>
                  <a:txBody>
                    <a:bodyPr/>
                    <a:lstStyle/>
                    <a:p>
                      <a:endParaRPr lang="es-AR" sz="1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s-AR" sz="1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s-AR" sz="1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es-AR" sz="100" b="1" kern="1200" dirty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es-AR" sz="100" b="1" kern="1200" dirty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es-AR" sz="100" b="1" kern="1200" dirty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s-AR" sz="1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s-AR" sz="1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9170892"/>
                  </a:ext>
                </a:extLst>
              </a:tr>
            </a:tbl>
          </a:graphicData>
        </a:graphic>
      </p:graphicFrame>
      <p:pic>
        <p:nvPicPr>
          <p:cNvPr id="24" name="Gráfico 23">
            <a:extLst>
              <a:ext uri="{FF2B5EF4-FFF2-40B4-BE49-F238E27FC236}">
                <a16:creationId xmlns:a16="http://schemas.microsoft.com/office/drawing/2014/main" id="{2A1C80D8-F461-7919-B1EA-E81B8D629FC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 l="1692" t="2009" r="73215" b="77871"/>
          <a:stretch/>
        </p:blipFill>
        <p:spPr>
          <a:xfrm>
            <a:off x="2506589" y="1548238"/>
            <a:ext cx="761957" cy="338554"/>
          </a:xfrm>
          <a:prstGeom prst="rect">
            <a:avLst/>
          </a:prstGeom>
        </p:spPr>
      </p:pic>
      <p:sp>
        <p:nvSpPr>
          <p:cNvPr id="32" name="CuadroTexto 31">
            <a:extLst>
              <a:ext uri="{FF2B5EF4-FFF2-40B4-BE49-F238E27FC236}">
                <a16:creationId xmlns:a16="http://schemas.microsoft.com/office/drawing/2014/main" id="{1879070F-BB2C-8A9E-D844-44D1063CC0D5}"/>
              </a:ext>
            </a:extLst>
          </p:cNvPr>
          <p:cNvSpPr txBox="1"/>
          <p:nvPr/>
        </p:nvSpPr>
        <p:spPr>
          <a:xfrm>
            <a:off x="2506589" y="1309489"/>
            <a:ext cx="7619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AR" sz="1000" b="1" dirty="0"/>
              <a:t>Color Key</a:t>
            </a:r>
          </a:p>
        </p:txBody>
      </p:sp>
      <p:graphicFrame>
        <p:nvGraphicFramePr>
          <p:cNvPr id="33" name="Tabla 8">
            <a:extLst>
              <a:ext uri="{FF2B5EF4-FFF2-40B4-BE49-F238E27FC236}">
                <a16:creationId xmlns:a16="http://schemas.microsoft.com/office/drawing/2014/main" id="{1E96A655-778B-34BF-BDB4-7E154E40D0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0240083"/>
              </p:ext>
            </p:extLst>
          </p:nvPr>
        </p:nvGraphicFramePr>
        <p:xfrm>
          <a:off x="2513829" y="1663282"/>
          <a:ext cx="747096" cy="338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6728">
                  <a:extLst>
                    <a:ext uri="{9D8B030D-6E8A-4147-A177-3AD203B41FA5}">
                      <a16:colId xmlns:a16="http://schemas.microsoft.com/office/drawing/2014/main" val="3048687879"/>
                    </a:ext>
                  </a:extLst>
                </a:gridCol>
                <a:gridCol w="106728">
                  <a:extLst>
                    <a:ext uri="{9D8B030D-6E8A-4147-A177-3AD203B41FA5}">
                      <a16:colId xmlns:a16="http://schemas.microsoft.com/office/drawing/2014/main" val="1803326168"/>
                    </a:ext>
                  </a:extLst>
                </a:gridCol>
                <a:gridCol w="106728">
                  <a:extLst>
                    <a:ext uri="{9D8B030D-6E8A-4147-A177-3AD203B41FA5}">
                      <a16:colId xmlns:a16="http://schemas.microsoft.com/office/drawing/2014/main" val="1152800066"/>
                    </a:ext>
                  </a:extLst>
                </a:gridCol>
                <a:gridCol w="106728">
                  <a:extLst>
                    <a:ext uri="{9D8B030D-6E8A-4147-A177-3AD203B41FA5}">
                      <a16:colId xmlns:a16="http://schemas.microsoft.com/office/drawing/2014/main" val="958640047"/>
                    </a:ext>
                  </a:extLst>
                </a:gridCol>
                <a:gridCol w="106728">
                  <a:extLst>
                    <a:ext uri="{9D8B030D-6E8A-4147-A177-3AD203B41FA5}">
                      <a16:colId xmlns:a16="http://schemas.microsoft.com/office/drawing/2014/main" val="1818967799"/>
                    </a:ext>
                  </a:extLst>
                </a:gridCol>
                <a:gridCol w="106728">
                  <a:extLst>
                    <a:ext uri="{9D8B030D-6E8A-4147-A177-3AD203B41FA5}">
                      <a16:colId xmlns:a16="http://schemas.microsoft.com/office/drawing/2014/main" val="977473853"/>
                    </a:ext>
                  </a:extLst>
                </a:gridCol>
                <a:gridCol w="106728">
                  <a:extLst>
                    <a:ext uri="{9D8B030D-6E8A-4147-A177-3AD203B41FA5}">
                      <a16:colId xmlns:a16="http://schemas.microsoft.com/office/drawing/2014/main" val="1929408398"/>
                    </a:ext>
                  </a:extLst>
                </a:gridCol>
              </a:tblGrid>
              <a:tr h="338554">
                <a:tc>
                  <a:txBody>
                    <a:bodyPr/>
                    <a:lstStyle/>
                    <a:p>
                      <a:pPr algn="ctr"/>
                      <a:r>
                        <a:rPr lang="es-AR" sz="400" b="0" dirty="0">
                          <a:solidFill>
                            <a:sysClr val="windowText" lastClr="000000"/>
                          </a:solidFill>
                        </a:rPr>
                        <a:t>-6</a:t>
                      </a: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AR" sz="400" b="0" dirty="0">
                          <a:solidFill>
                            <a:sysClr val="windowText" lastClr="000000"/>
                          </a:solidFill>
                        </a:rPr>
                        <a:t>-4</a:t>
                      </a: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AR" sz="400" b="0" dirty="0">
                          <a:solidFill>
                            <a:sysClr val="windowText" lastClr="000000"/>
                          </a:solidFill>
                        </a:rPr>
                        <a:t>-2</a:t>
                      </a: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s-AR" sz="400" b="0" kern="1200" dirty="0">
                          <a:solidFill>
                            <a:sysClr val="windowText" lastClr="000000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0" marR="0" marT="0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s-AR" sz="400" b="0" kern="1200" dirty="0">
                          <a:solidFill>
                            <a:sysClr val="windowText" lastClr="000000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0" marR="0" marT="0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s-AR" sz="400" b="0" kern="1200" dirty="0">
                          <a:solidFill>
                            <a:sysClr val="windowText" lastClr="000000"/>
                          </a:solidFill>
                          <a:latin typeface="+mn-lt"/>
                          <a:ea typeface="+mn-ea"/>
                          <a:cs typeface="+mn-cs"/>
                        </a:rPr>
                        <a:t>4</a:t>
                      </a:r>
                    </a:p>
                  </a:txBody>
                  <a:tcPr marL="0" marR="0" marT="0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AR" sz="400" b="0" dirty="0">
                          <a:solidFill>
                            <a:sysClr val="windowText" lastClr="000000"/>
                          </a:solidFill>
                        </a:rPr>
                        <a:t>6</a:t>
                      </a:r>
                    </a:p>
                  </a:txBody>
                  <a:tcPr marL="0" marR="0" marT="0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9170892"/>
                  </a:ext>
                </a:extLst>
              </a:tr>
            </a:tbl>
          </a:graphicData>
        </a:graphic>
      </p:graphicFrame>
      <p:sp>
        <p:nvSpPr>
          <p:cNvPr id="34" name="CuadroTexto 33">
            <a:extLst>
              <a:ext uri="{FF2B5EF4-FFF2-40B4-BE49-F238E27FC236}">
                <a16:creationId xmlns:a16="http://schemas.microsoft.com/office/drawing/2014/main" id="{73B978A8-0059-FF58-0A48-1E7742E57136}"/>
              </a:ext>
            </a:extLst>
          </p:cNvPr>
          <p:cNvSpPr txBox="1"/>
          <p:nvPr/>
        </p:nvSpPr>
        <p:spPr>
          <a:xfrm>
            <a:off x="2506588" y="1945955"/>
            <a:ext cx="7619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AR" sz="700" b="1" dirty="0" err="1"/>
              <a:t>value</a:t>
            </a:r>
            <a:endParaRPr lang="es-AR" sz="700" b="1" dirty="0"/>
          </a:p>
        </p:txBody>
      </p:sp>
      <p:graphicFrame>
        <p:nvGraphicFramePr>
          <p:cNvPr id="35" name="Gráfico 34">
            <a:extLst>
              <a:ext uri="{FF2B5EF4-FFF2-40B4-BE49-F238E27FC236}">
                <a16:creationId xmlns:a16="http://schemas.microsoft.com/office/drawing/2014/main" id="{E6CFA6B8-6207-8546-9A0A-676675DE8EC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782506"/>
              </p:ext>
            </p:extLst>
          </p:nvPr>
        </p:nvGraphicFramePr>
        <p:xfrm>
          <a:off x="2974171" y="3486609"/>
          <a:ext cx="8507489" cy="26775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6" name="テキスト ボックス 27">
            <a:extLst>
              <a:ext uri="{FF2B5EF4-FFF2-40B4-BE49-F238E27FC236}">
                <a16:creationId xmlns:a16="http://schemas.microsoft.com/office/drawing/2014/main" id="{A1E7A9EB-017B-14AB-01EF-B789CF85846C}"/>
              </a:ext>
            </a:extLst>
          </p:cNvPr>
          <p:cNvSpPr txBox="1"/>
          <p:nvPr/>
        </p:nvSpPr>
        <p:spPr>
          <a:xfrm rot="16200000">
            <a:off x="1564135" y="4635337"/>
            <a:ext cx="1994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ld</a:t>
            </a:r>
            <a:r>
              <a:rPr lang="es-A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A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nges</a:t>
            </a:r>
            <a:r>
              <a:rPr lang="es-A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og</a:t>
            </a:r>
            <a:r>
              <a:rPr lang="es-A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A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tio)</a:t>
            </a:r>
            <a:endParaRPr kumimoji="1" lang="ja-JP" altLang="en-US" sz="1400" dirty="0">
              <a:latin typeface="Times New Roman" panose="02020603050405020304" pitchFamily="18" charset="0"/>
              <a:ea typeface="Meiryo UI" pitchFamily="50" charset="-128"/>
              <a:cs typeface="Times New Roman" pitchFamily="18" charset="0"/>
            </a:endParaRPr>
          </a:p>
        </p:txBody>
      </p:sp>
      <p:sp>
        <p:nvSpPr>
          <p:cNvPr id="37" name="Rectángulo 36">
            <a:extLst>
              <a:ext uri="{FF2B5EF4-FFF2-40B4-BE49-F238E27FC236}">
                <a16:creationId xmlns:a16="http://schemas.microsoft.com/office/drawing/2014/main" id="{CCA09910-B115-5A0A-906D-C84DDC4C5DE7}"/>
              </a:ext>
            </a:extLst>
          </p:cNvPr>
          <p:cNvSpPr/>
          <p:nvPr/>
        </p:nvSpPr>
        <p:spPr>
          <a:xfrm>
            <a:off x="3690495" y="3343360"/>
            <a:ext cx="1338317" cy="770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AR"/>
          </a:p>
        </p:txBody>
      </p:sp>
      <p:grpSp>
        <p:nvGrpSpPr>
          <p:cNvPr id="38" name="Grupo 37">
            <a:extLst>
              <a:ext uri="{FF2B5EF4-FFF2-40B4-BE49-F238E27FC236}">
                <a16:creationId xmlns:a16="http://schemas.microsoft.com/office/drawing/2014/main" id="{6BD0DBEE-5EFC-338D-A5F9-EFFFC07ED7ED}"/>
              </a:ext>
            </a:extLst>
          </p:cNvPr>
          <p:cNvGrpSpPr/>
          <p:nvPr/>
        </p:nvGrpSpPr>
        <p:grpSpPr>
          <a:xfrm>
            <a:off x="3265472" y="5962966"/>
            <a:ext cx="8146917" cy="1008671"/>
            <a:chOff x="2615750" y="5842190"/>
            <a:chExt cx="8146917" cy="1008671"/>
          </a:xfrm>
        </p:grpSpPr>
        <p:sp>
          <p:nvSpPr>
            <p:cNvPr id="39" name="Rectángulo 38">
              <a:extLst>
                <a:ext uri="{FF2B5EF4-FFF2-40B4-BE49-F238E27FC236}">
                  <a16:creationId xmlns:a16="http://schemas.microsoft.com/office/drawing/2014/main" id="{A45FBFB2-D3B1-1C02-3D06-30DDD3BF62C9}"/>
                </a:ext>
              </a:extLst>
            </p:cNvPr>
            <p:cNvSpPr/>
            <p:nvPr/>
          </p:nvSpPr>
          <p:spPr>
            <a:xfrm>
              <a:off x="2716888" y="5842190"/>
              <a:ext cx="8045779" cy="21858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  <p:sp>
          <p:nvSpPr>
            <p:cNvPr id="40" name="Rectángulo 39">
              <a:extLst>
                <a:ext uri="{FF2B5EF4-FFF2-40B4-BE49-F238E27FC236}">
                  <a16:creationId xmlns:a16="http://schemas.microsoft.com/office/drawing/2014/main" id="{23946268-84BF-40D3-5F3A-5A7173242711}"/>
                </a:ext>
              </a:extLst>
            </p:cNvPr>
            <p:cNvSpPr/>
            <p:nvPr/>
          </p:nvSpPr>
          <p:spPr>
            <a:xfrm>
              <a:off x="8648806" y="6773786"/>
              <a:ext cx="1338317" cy="770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3B86C824-562D-09AB-D4EF-E9764417E62A}"/>
                </a:ext>
              </a:extLst>
            </p:cNvPr>
            <p:cNvSpPr txBox="1"/>
            <p:nvPr/>
          </p:nvSpPr>
          <p:spPr>
            <a:xfrm rot="16200000">
              <a:off x="2451109" y="6015051"/>
              <a:ext cx="617430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164</a:t>
              </a:r>
            </a:p>
          </p:txBody>
        </p:sp>
        <p:sp>
          <p:nvSpPr>
            <p:cNvPr id="102" name="CuadroTexto 101">
              <a:extLst>
                <a:ext uri="{FF2B5EF4-FFF2-40B4-BE49-F238E27FC236}">
                  <a16:creationId xmlns:a16="http://schemas.microsoft.com/office/drawing/2014/main" id="{D7CFE086-1CE0-62C3-E74B-E437CD68E49C}"/>
                </a:ext>
              </a:extLst>
            </p:cNvPr>
            <p:cNvSpPr txBox="1"/>
            <p:nvPr/>
          </p:nvSpPr>
          <p:spPr>
            <a:xfrm rot="16200000">
              <a:off x="2766307" y="6095936"/>
              <a:ext cx="783177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200r2</a:t>
              </a:r>
            </a:p>
          </p:txBody>
        </p:sp>
        <p:sp>
          <p:nvSpPr>
            <p:cNvPr id="104" name="CuadroTexto 103">
              <a:extLst>
                <a:ext uri="{FF2B5EF4-FFF2-40B4-BE49-F238E27FC236}">
                  <a16:creationId xmlns:a16="http://schemas.microsoft.com/office/drawing/2014/main" id="{209B44C0-A7E2-F15A-BD17-69527171F956}"/>
                </a:ext>
              </a:extLst>
            </p:cNvPr>
            <p:cNvSpPr txBox="1"/>
            <p:nvPr/>
          </p:nvSpPr>
          <p:spPr>
            <a:xfrm rot="16200000">
              <a:off x="3101047" y="6133629"/>
              <a:ext cx="854588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200r4</a:t>
              </a:r>
            </a:p>
          </p:txBody>
        </p:sp>
        <p:sp>
          <p:nvSpPr>
            <p:cNvPr id="105" name="CuadroTexto 104">
              <a:extLst>
                <a:ext uri="{FF2B5EF4-FFF2-40B4-BE49-F238E27FC236}">
                  <a16:creationId xmlns:a16="http://schemas.microsoft.com/office/drawing/2014/main" id="{5E8E1B3B-3197-7D3F-7908-81E29A65CE81}"/>
                </a:ext>
              </a:extLst>
            </p:cNvPr>
            <p:cNvSpPr txBox="1"/>
            <p:nvPr/>
          </p:nvSpPr>
          <p:spPr>
            <a:xfrm rot="16200000">
              <a:off x="3513099" y="6083897"/>
              <a:ext cx="759102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209a</a:t>
              </a:r>
            </a:p>
          </p:txBody>
        </p:sp>
        <p:sp>
          <p:nvSpPr>
            <p:cNvPr id="106" name="CuadroTexto 105">
              <a:extLst>
                <a:ext uri="{FF2B5EF4-FFF2-40B4-BE49-F238E27FC236}">
                  <a16:creationId xmlns:a16="http://schemas.microsoft.com/office/drawing/2014/main" id="{0D03BCF2-49A4-3AFF-A206-624F335DD251}"/>
                </a:ext>
              </a:extLst>
            </p:cNvPr>
            <p:cNvSpPr txBox="1"/>
            <p:nvPr/>
          </p:nvSpPr>
          <p:spPr>
            <a:xfrm rot="16200000">
              <a:off x="3900967" y="6096930"/>
              <a:ext cx="781189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200b</a:t>
              </a:r>
            </a:p>
          </p:txBody>
        </p:sp>
        <p:sp>
          <p:nvSpPr>
            <p:cNvPr id="107" name="CuadroTexto 106">
              <a:extLst>
                <a:ext uri="{FF2B5EF4-FFF2-40B4-BE49-F238E27FC236}">
                  <a16:creationId xmlns:a16="http://schemas.microsoft.com/office/drawing/2014/main" id="{84388613-78A6-3FDE-06FD-0E3EF14C6B78}"/>
                </a:ext>
              </a:extLst>
            </p:cNvPr>
            <p:cNvSpPr txBox="1"/>
            <p:nvPr/>
          </p:nvSpPr>
          <p:spPr>
            <a:xfrm rot="16200000">
              <a:off x="4349923" y="6040871"/>
              <a:ext cx="617430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8</a:t>
              </a:r>
            </a:p>
          </p:txBody>
        </p:sp>
        <p:sp>
          <p:nvSpPr>
            <p:cNvPr id="108" name="CuadroTexto 107">
              <a:extLst>
                <a:ext uri="{FF2B5EF4-FFF2-40B4-BE49-F238E27FC236}">
                  <a16:creationId xmlns:a16="http://schemas.microsoft.com/office/drawing/2014/main" id="{2693690A-7133-FB16-CF54-B9C6B51A6E56}"/>
                </a:ext>
              </a:extLst>
            </p:cNvPr>
            <p:cNvSpPr txBox="1"/>
            <p:nvPr/>
          </p:nvSpPr>
          <p:spPr>
            <a:xfrm rot="16200000">
              <a:off x="4726235" y="6057781"/>
              <a:ext cx="677108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0</a:t>
              </a:r>
            </a:p>
          </p:txBody>
        </p:sp>
        <p:sp>
          <p:nvSpPr>
            <p:cNvPr id="109" name="CuadroTexto 108">
              <a:extLst>
                <a:ext uri="{FF2B5EF4-FFF2-40B4-BE49-F238E27FC236}">
                  <a16:creationId xmlns:a16="http://schemas.microsoft.com/office/drawing/2014/main" id="{7652649B-66A8-2C25-FF37-89B7A0B2AD85}"/>
                </a:ext>
              </a:extLst>
            </p:cNvPr>
            <p:cNvSpPr txBox="1"/>
            <p:nvPr/>
          </p:nvSpPr>
          <p:spPr>
            <a:xfrm rot="16200000">
              <a:off x="5534245" y="6030132"/>
              <a:ext cx="617430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0</a:t>
              </a:r>
            </a:p>
          </p:txBody>
        </p:sp>
        <p:sp>
          <p:nvSpPr>
            <p:cNvPr id="110" name="CuadroTexto 109">
              <a:extLst>
                <a:ext uri="{FF2B5EF4-FFF2-40B4-BE49-F238E27FC236}">
                  <a16:creationId xmlns:a16="http://schemas.microsoft.com/office/drawing/2014/main" id="{BC316A9B-0B25-C2CC-8A1A-4216E08C487C}"/>
                </a:ext>
              </a:extLst>
            </p:cNvPr>
            <p:cNvSpPr txBox="1"/>
            <p:nvPr/>
          </p:nvSpPr>
          <p:spPr>
            <a:xfrm rot="16200000">
              <a:off x="5040605" y="6099903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69</a:t>
              </a:r>
            </a:p>
          </p:txBody>
        </p:sp>
        <p:sp>
          <p:nvSpPr>
            <p:cNvPr id="111" name="CuadroTexto 110">
              <a:extLst>
                <a:ext uri="{FF2B5EF4-FFF2-40B4-BE49-F238E27FC236}">
                  <a16:creationId xmlns:a16="http://schemas.microsoft.com/office/drawing/2014/main" id="{70A96150-F648-FBB6-D6EC-8E9FD2560706}"/>
                </a:ext>
              </a:extLst>
            </p:cNvPr>
            <p:cNvSpPr txBox="1"/>
            <p:nvPr/>
          </p:nvSpPr>
          <p:spPr>
            <a:xfrm rot="16200000">
              <a:off x="5912692" y="6023785"/>
              <a:ext cx="617430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3</a:t>
              </a:r>
            </a:p>
          </p:txBody>
        </p:sp>
        <p:sp>
          <p:nvSpPr>
            <p:cNvPr id="112" name="CuadroTexto 111">
              <a:extLst>
                <a:ext uri="{FF2B5EF4-FFF2-40B4-BE49-F238E27FC236}">
                  <a16:creationId xmlns:a16="http://schemas.microsoft.com/office/drawing/2014/main" id="{8EB30779-D54A-8CE4-EA63-9FA070BD5332}"/>
                </a:ext>
              </a:extLst>
            </p:cNvPr>
            <p:cNvSpPr txBox="1"/>
            <p:nvPr/>
          </p:nvSpPr>
          <p:spPr>
            <a:xfrm rot="16200000">
              <a:off x="6336980" y="6027940"/>
              <a:ext cx="617430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6</a:t>
              </a:r>
            </a:p>
          </p:txBody>
        </p:sp>
        <p:sp>
          <p:nvSpPr>
            <p:cNvPr id="113" name="CuadroTexto 112">
              <a:extLst>
                <a:ext uri="{FF2B5EF4-FFF2-40B4-BE49-F238E27FC236}">
                  <a16:creationId xmlns:a16="http://schemas.microsoft.com/office/drawing/2014/main" id="{21A48A8F-AD6F-2BFC-CB5C-8F621DF67ABB}"/>
                </a:ext>
              </a:extLst>
            </p:cNvPr>
            <p:cNvSpPr txBox="1"/>
            <p:nvPr/>
          </p:nvSpPr>
          <p:spPr>
            <a:xfrm rot="16200000">
              <a:off x="6686418" y="6020696"/>
              <a:ext cx="617430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cgr1</a:t>
              </a:r>
            </a:p>
          </p:txBody>
        </p:sp>
        <p:sp>
          <p:nvSpPr>
            <p:cNvPr id="114" name="CuadroTexto 113">
              <a:extLst>
                <a:ext uri="{FF2B5EF4-FFF2-40B4-BE49-F238E27FC236}">
                  <a16:creationId xmlns:a16="http://schemas.microsoft.com/office/drawing/2014/main" id="{87F8F0F7-3D6A-22E9-4875-CBE44C39831F}"/>
                </a:ext>
              </a:extLst>
            </p:cNvPr>
            <p:cNvSpPr txBox="1"/>
            <p:nvPr/>
          </p:nvSpPr>
          <p:spPr>
            <a:xfrm rot="16200000">
              <a:off x="7069022" y="6020161"/>
              <a:ext cx="617430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cgr4</a:t>
              </a:r>
            </a:p>
          </p:txBody>
        </p:sp>
        <p:sp>
          <p:nvSpPr>
            <p:cNvPr id="115" name="CuadroTexto 114">
              <a:extLst>
                <a:ext uri="{FF2B5EF4-FFF2-40B4-BE49-F238E27FC236}">
                  <a16:creationId xmlns:a16="http://schemas.microsoft.com/office/drawing/2014/main" id="{497A887C-C594-1CDA-724E-6C31093D657C}"/>
                </a:ext>
              </a:extLst>
            </p:cNvPr>
            <p:cNvSpPr txBox="1"/>
            <p:nvPr/>
          </p:nvSpPr>
          <p:spPr>
            <a:xfrm rot="16200000">
              <a:off x="7379787" y="6098250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cmr</a:t>
              </a:r>
              <a:endParaRPr lang="es-A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CuadroTexto 115">
              <a:extLst>
                <a:ext uri="{FF2B5EF4-FFF2-40B4-BE49-F238E27FC236}">
                  <a16:creationId xmlns:a16="http://schemas.microsoft.com/office/drawing/2014/main" id="{4F6ED042-BD8E-E908-AC64-3146F20BBF0D}"/>
                </a:ext>
              </a:extLst>
            </p:cNvPr>
            <p:cNvSpPr txBox="1"/>
            <p:nvPr/>
          </p:nvSpPr>
          <p:spPr>
            <a:xfrm rot="16200000">
              <a:off x="7769469" y="6106848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2-K1</a:t>
              </a:r>
            </a:p>
          </p:txBody>
        </p:sp>
        <p:sp>
          <p:nvSpPr>
            <p:cNvPr id="117" name="CuadroTexto 116">
              <a:extLst>
                <a:ext uri="{FF2B5EF4-FFF2-40B4-BE49-F238E27FC236}">
                  <a16:creationId xmlns:a16="http://schemas.microsoft.com/office/drawing/2014/main" id="{B7D6A529-4DCC-BD70-C1EC-A768B825685E}"/>
                </a:ext>
              </a:extLst>
            </p:cNvPr>
            <p:cNvSpPr txBox="1"/>
            <p:nvPr/>
          </p:nvSpPr>
          <p:spPr>
            <a:xfrm rot="16200000">
              <a:off x="8167706" y="6092657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2-M3</a:t>
              </a:r>
            </a:p>
          </p:txBody>
        </p:sp>
        <p:sp>
          <p:nvSpPr>
            <p:cNvPr id="118" name="CuadroTexto 117">
              <a:extLst>
                <a:ext uri="{FF2B5EF4-FFF2-40B4-BE49-F238E27FC236}">
                  <a16:creationId xmlns:a16="http://schemas.microsoft.com/office/drawing/2014/main" id="{53F30812-A825-9009-41FA-2FB365858B23}"/>
                </a:ext>
              </a:extLst>
            </p:cNvPr>
            <p:cNvSpPr txBox="1"/>
            <p:nvPr/>
          </p:nvSpPr>
          <p:spPr>
            <a:xfrm rot="16200000">
              <a:off x="8523187" y="6099901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2-Q10</a:t>
              </a:r>
            </a:p>
          </p:txBody>
        </p:sp>
        <p:sp>
          <p:nvSpPr>
            <p:cNvPr id="119" name="CuadroTexto 118">
              <a:extLst>
                <a:ext uri="{FF2B5EF4-FFF2-40B4-BE49-F238E27FC236}">
                  <a16:creationId xmlns:a16="http://schemas.microsoft.com/office/drawing/2014/main" id="{DAC3BD7B-4EDB-2427-C4DF-3598DD325DF1}"/>
                </a:ext>
              </a:extLst>
            </p:cNvPr>
            <p:cNvSpPr txBox="1"/>
            <p:nvPr/>
          </p:nvSpPr>
          <p:spPr>
            <a:xfrm rot="16200000">
              <a:off x="8918375" y="6106847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2-T10</a:t>
              </a:r>
            </a:p>
          </p:txBody>
        </p:sp>
        <p:sp>
          <p:nvSpPr>
            <p:cNvPr id="120" name="CuadroTexto 119">
              <a:extLst>
                <a:ext uri="{FF2B5EF4-FFF2-40B4-BE49-F238E27FC236}">
                  <a16:creationId xmlns:a16="http://schemas.microsoft.com/office/drawing/2014/main" id="{CCCA3863-2A89-2CE3-2519-A396C8590414}"/>
                </a:ext>
              </a:extLst>
            </p:cNvPr>
            <p:cNvSpPr txBox="1"/>
            <p:nvPr/>
          </p:nvSpPr>
          <p:spPr>
            <a:xfrm rot="16200000">
              <a:off x="9302721" y="6100962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2-T22</a:t>
              </a:r>
            </a:p>
          </p:txBody>
        </p:sp>
        <p:sp>
          <p:nvSpPr>
            <p:cNvPr id="121" name="CuadroTexto 120">
              <a:extLst>
                <a:ext uri="{FF2B5EF4-FFF2-40B4-BE49-F238E27FC236}">
                  <a16:creationId xmlns:a16="http://schemas.microsoft.com/office/drawing/2014/main" id="{ED9E1C9B-F773-F680-4837-A990BB4ED448}"/>
                </a:ext>
              </a:extLst>
            </p:cNvPr>
            <p:cNvSpPr txBox="1"/>
            <p:nvPr/>
          </p:nvSpPr>
          <p:spPr>
            <a:xfrm rot="16200000">
              <a:off x="9686848" y="6090586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glec1</a:t>
              </a:r>
            </a:p>
          </p:txBody>
        </p:sp>
        <p:sp>
          <p:nvSpPr>
            <p:cNvPr id="122" name="CuadroTexto 121">
              <a:extLst>
                <a:ext uri="{FF2B5EF4-FFF2-40B4-BE49-F238E27FC236}">
                  <a16:creationId xmlns:a16="http://schemas.microsoft.com/office/drawing/2014/main" id="{9C3AC4E2-F1DE-E4C7-DF8A-6320B68546B8}"/>
                </a:ext>
              </a:extLst>
            </p:cNvPr>
            <p:cNvSpPr txBox="1"/>
            <p:nvPr/>
          </p:nvSpPr>
          <p:spPr>
            <a:xfrm rot="16200000">
              <a:off x="10105489" y="6106846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iglecf</a:t>
              </a:r>
              <a:endParaRPr lang="es-A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3" name="Grupo 122">
            <a:extLst>
              <a:ext uri="{FF2B5EF4-FFF2-40B4-BE49-F238E27FC236}">
                <a16:creationId xmlns:a16="http://schemas.microsoft.com/office/drawing/2014/main" id="{CC1E9AAF-3D21-C5D3-4FF2-0B30393C1E41}"/>
              </a:ext>
            </a:extLst>
          </p:cNvPr>
          <p:cNvGrpSpPr/>
          <p:nvPr/>
        </p:nvGrpSpPr>
        <p:grpSpPr>
          <a:xfrm>
            <a:off x="10374627" y="2863784"/>
            <a:ext cx="1493367" cy="288147"/>
            <a:chOff x="9485219" y="1622455"/>
            <a:chExt cx="1493367" cy="288147"/>
          </a:xfrm>
        </p:grpSpPr>
        <p:sp>
          <p:nvSpPr>
            <p:cNvPr id="124" name="CuadroTexto 123">
              <a:extLst>
                <a:ext uri="{FF2B5EF4-FFF2-40B4-BE49-F238E27FC236}">
                  <a16:creationId xmlns:a16="http://schemas.microsoft.com/office/drawing/2014/main" id="{9FF0AAFD-211E-3AB7-8359-65714FADF227}"/>
                </a:ext>
              </a:extLst>
            </p:cNvPr>
            <p:cNvSpPr txBox="1"/>
            <p:nvPr/>
          </p:nvSpPr>
          <p:spPr>
            <a:xfrm>
              <a:off x="9485219" y="1622455"/>
              <a:ext cx="1189292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ct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PS</a:t>
              </a:r>
            </a:p>
          </p:txBody>
        </p:sp>
        <p:sp>
          <p:nvSpPr>
            <p:cNvPr id="125" name="Rectángulo 124">
              <a:extLst>
                <a:ext uri="{FF2B5EF4-FFF2-40B4-BE49-F238E27FC236}">
                  <a16:creationId xmlns:a16="http://schemas.microsoft.com/office/drawing/2014/main" id="{17A84823-B1CC-B960-9FA8-EA3270A94984}"/>
                </a:ext>
              </a:extLst>
            </p:cNvPr>
            <p:cNvSpPr/>
            <p:nvPr/>
          </p:nvSpPr>
          <p:spPr>
            <a:xfrm>
              <a:off x="10756416" y="1671463"/>
              <a:ext cx="222170" cy="199555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</p:grpSp>
      <p:grpSp>
        <p:nvGrpSpPr>
          <p:cNvPr id="126" name="Grupo 125">
            <a:extLst>
              <a:ext uri="{FF2B5EF4-FFF2-40B4-BE49-F238E27FC236}">
                <a16:creationId xmlns:a16="http://schemas.microsoft.com/office/drawing/2014/main" id="{5B93B183-0195-7FD9-681C-62FB1B83C599}"/>
              </a:ext>
            </a:extLst>
          </p:cNvPr>
          <p:cNvGrpSpPr/>
          <p:nvPr/>
        </p:nvGrpSpPr>
        <p:grpSpPr>
          <a:xfrm>
            <a:off x="10376294" y="2379482"/>
            <a:ext cx="1490275" cy="288147"/>
            <a:chOff x="9486199" y="2104597"/>
            <a:chExt cx="1490275" cy="288147"/>
          </a:xfrm>
        </p:grpSpPr>
        <p:sp>
          <p:nvSpPr>
            <p:cNvPr id="127" name="CuadroTexto 126">
              <a:extLst>
                <a:ext uri="{FF2B5EF4-FFF2-40B4-BE49-F238E27FC236}">
                  <a16:creationId xmlns:a16="http://schemas.microsoft.com/office/drawing/2014/main" id="{1E5DB6AF-E7DC-C431-D9CF-06A7CB67E064}"/>
                </a:ext>
              </a:extLst>
            </p:cNvPr>
            <p:cNvSpPr txBox="1"/>
            <p:nvPr/>
          </p:nvSpPr>
          <p:spPr>
            <a:xfrm>
              <a:off x="9486199" y="2104597"/>
              <a:ext cx="1188311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ct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1 + LPS</a:t>
              </a:r>
            </a:p>
          </p:txBody>
        </p:sp>
        <p:sp>
          <p:nvSpPr>
            <p:cNvPr id="128" name="Rectángulo 127">
              <a:extLst>
                <a:ext uri="{FF2B5EF4-FFF2-40B4-BE49-F238E27FC236}">
                  <a16:creationId xmlns:a16="http://schemas.microsoft.com/office/drawing/2014/main" id="{49DED265-0253-BF68-BC7D-F3AD514B9D82}"/>
                </a:ext>
              </a:extLst>
            </p:cNvPr>
            <p:cNvSpPr/>
            <p:nvPr/>
          </p:nvSpPr>
          <p:spPr>
            <a:xfrm>
              <a:off x="10754304" y="2107890"/>
              <a:ext cx="222170" cy="199555"/>
            </a:xfrm>
            <a:prstGeom prst="rect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</p:grpSp>
      <p:grpSp>
        <p:nvGrpSpPr>
          <p:cNvPr id="129" name="Grupo 128">
            <a:extLst>
              <a:ext uri="{FF2B5EF4-FFF2-40B4-BE49-F238E27FC236}">
                <a16:creationId xmlns:a16="http://schemas.microsoft.com/office/drawing/2014/main" id="{860EB3A5-A223-FE7B-510C-E2DB58F1ED28}"/>
              </a:ext>
            </a:extLst>
          </p:cNvPr>
          <p:cNvGrpSpPr/>
          <p:nvPr/>
        </p:nvGrpSpPr>
        <p:grpSpPr>
          <a:xfrm>
            <a:off x="10374900" y="1925373"/>
            <a:ext cx="1499013" cy="288147"/>
            <a:chOff x="9479573" y="2583677"/>
            <a:chExt cx="1499013" cy="288147"/>
          </a:xfrm>
        </p:grpSpPr>
        <p:sp>
          <p:nvSpPr>
            <p:cNvPr id="130" name="CuadroTexto 129">
              <a:extLst>
                <a:ext uri="{FF2B5EF4-FFF2-40B4-BE49-F238E27FC236}">
                  <a16:creationId xmlns:a16="http://schemas.microsoft.com/office/drawing/2014/main" id="{F6D8CE3E-7DC9-B0A4-0E7B-4E13B077C510}"/>
                </a:ext>
              </a:extLst>
            </p:cNvPr>
            <p:cNvSpPr txBox="1"/>
            <p:nvPr/>
          </p:nvSpPr>
          <p:spPr>
            <a:xfrm>
              <a:off x="9479573" y="2583677"/>
              <a:ext cx="1190523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ct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3 + LPS</a:t>
              </a:r>
            </a:p>
          </p:txBody>
        </p:sp>
        <p:sp>
          <p:nvSpPr>
            <p:cNvPr id="131" name="Rectángulo 130">
              <a:extLst>
                <a:ext uri="{FF2B5EF4-FFF2-40B4-BE49-F238E27FC236}">
                  <a16:creationId xmlns:a16="http://schemas.microsoft.com/office/drawing/2014/main" id="{7D5977D1-ECA4-A3EB-405C-9F427E5A3488}"/>
                </a:ext>
              </a:extLst>
            </p:cNvPr>
            <p:cNvSpPr/>
            <p:nvPr/>
          </p:nvSpPr>
          <p:spPr>
            <a:xfrm>
              <a:off x="10756416" y="2599155"/>
              <a:ext cx="222170" cy="199555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</p:grpSp>
      <p:sp>
        <p:nvSpPr>
          <p:cNvPr id="132" name="CuadroTexto 131">
            <a:extLst>
              <a:ext uri="{FF2B5EF4-FFF2-40B4-BE49-F238E27FC236}">
                <a16:creationId xmlns:a16="http://schemas.microsoft.com/office/drawing/2014/main" id="{43FA29F9-BF6D-AD2D-9630-D78B83CCD566}"/>
              </a:ext>
            </a:extLst>
          </p:cNvPr>
          <p:cNvSpPr txBox="1"/>
          <p:nvPr/>
        </p:nvSpPr>
        <p:spPr>
          <a:xfrm>
            <a:off x="3404127" y="5293832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33" name="CuadroTexto 132">
            <a:extLst>
              <a:ext uri="{FF2B5EF4-FFF2-40B4-BE49-F238E27FC236}">
                <a16:creationId xmlns:a16="http://schemas.microsoft.com/office/drawing/2014/main" id="{B66D6516-FF97-E3F2-FCD6-DACB4577D952}"/>
              </a:ext>
            </a:extLst>
          </p:cNvPr>
          <p:cNvSpPr txBox="1"/>
          <p:nvPr/>
        </p:nvSpPr>
        <p:spPr>
          <a:xfrm>
            <a:off x="3321215" y="565211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34" name="CuadroTexto 133">
            <a:extLst>
              <a:ext uri="{FF2B5EF4-FFF2-40B4-BE49-F238E27FC236}">
                <a16:creationId xmlns:a16="http://schemas.microsoft.com/office/drawing/2014/main" id="{A1AABE06-0193-9891-43E4-F8145E4C2ED8}"/>
              </a:ext>
            </a:extLst>
          </p:cNvPr>
          <p:cNvSpPr txBox="1"/>
          <p:nvPr/>
        </p:nvSpPr>
        <p:spPr>
          <a:xfrm>
            <a:off x="3747693" y="564599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35" name="CuadroTexto 134">
            <a:extLst>
              <a:ext uri="{FF2B5EF4-FFF2-40B4-BE49-F238E27FC236}">
                <a16:creationId xmlns:a16="http://schemas.microsoft.com/office/drawing/2014/main" id="{3FA23917-860B-A6A3-AA30-F50DB15F1B8B}"/>
              </a:ext>
            </a:extLst>
          </p:cNvPr>
          <p:cNvSpPr txBox="1"/>
          <p:nvPr/>
        </p:nvSpPr>
        <p:spPr>
          <a:xfrm>
            <a:off x="3850217" y="564876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36" name="CuadroTexto 135">
            <a:extLst>
              <a:ext uri="{FF2B5EF4-FFF2-40B4-BE49-F238E27FC236}">
                <a16:creationId xmlns:a16="http://schemas.microsoft.com/office/drawing/2014/main" id="{2C37A04A-2708-FCCE-9E65-5F3648E4CA02}"/>
              </a:ext>
            </a:extLst>
          </p:cNvPr>
          <p:cNvSpPr txBox="1"/>
          <p:nvPr/>
        </p:nvSpPr>
        <p:spPr>
          <a:xfrm>
            <a:off x="4095971" y="509264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37" name="CuadroTexto 136">
            <a:extLst>
              <a:ext uri="{FF2B5EF4-FFF2-40B4-BE49-F238E27FC236}">
                <a16:creationId xmlns:a16="http://schemas.microsoft.com/office/drawing/2014/main" id="{98F3D58A-10B7-BA80-35A9-0DF2F7CBD57F}"/>
              </a:ext>
            </a:extLst>
          </p:cNvPr>
          <p:cNvSpPr txBox="1"/>
          <p:nvPr/>
        </p:nvSpPr>
        <p:spPr>
          <a:xfrm>
            <a:off x="4194339" y="517438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38" name="CuadroTexto 137">
            <a:extLst>
              <a:ext uri="{FF2B5EF4-FFF2-40B4-BE49-F238E27FC236}">
                <a16:creationId xmlns:a16="http://schemas.microsoft.com/office/drawing/2014/main" id="{1040C842-A714-20DD-032F-E29D748F860C}"/>
              </a:ext>
            </a:extLst>
          </p:cNvPr>
          <p:cNvSpPr txBox="1"/>
          <p:nvPr/>
        </p:nvSpPr>
        <p:spPr>
          <a:xfrm>
            <a:off x="4502761" y="565292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39" name="CuadroTexto 138">
            <a:extLst>
              <a:ext uri="{FF2B5EF4-FFF2-40B4-BE49-F238E27FC236}">
                <a16:creationId xmlns:a16="http://schemas.microsoft.com/office/drawing/2014/main" id="{5A0502C2-D1E0-7A8F-6CE8-69B1AA292B64}"/>
              </a:ext>
            </a:extLst>
          </p:cNvPr>
          <p:cNvSpPr txBox="1"/>
          <p:nvPr/>
        </p:nvSpPr>
        <p:spPr>
          <a:xfrm>
            <a:off x="4605285" y="565569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40" name="CuadroTexto 139">
            <a:extLst>
              <a:ext uri="{FF2B5EF4-FFF2-40B4-BE49-F238E27FC236}">
                <a16:creationId xmlns:a16="http://schemas.microsoft.com/office/drawing/2014/main" id="{27AFD459-8036-9EE6-3E2A-B8CD366FAF10}"/>
              </a:ext>
            </a:extLst>
          </p:cNvPr>
          <p:cNvSpPr txBox="1"/>
          <p:nvPr/>
        </p:nvSpPr>
        <p:spPr>
          <a:xfrm>
            <a:off x="4839402" y="425638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</a:p>
        </p:txBody>
      </p:sp>
      <p:sp>
        <p:nvSpPr>
          <p:cNvPr id="141" name="CuadroTexto 140">
            <a:extLst>
              <a:ext uri="{FF2B5EF4-FFF2-40B4-BE49-F238E27FC236}">
                <a16:creationId xmlns:a16="http://schemas.microsoft.com/office/drawing/2014/main" id="{EA3F8DEF-15E7-F96A-D6A6-9453B566A9CE}"/>
              </a:ext>
            </a:extLst>
          </p:cNvPr>
          <p:cNvSpPr txBox="1"/>
          <p:nvPr/>
        </p:nvSpPr>
        <p:spPr>
          <a:xfrm>
            <a:off x="4983125" y="563466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42" name="CuadroTexto 141">
            <a:extLst>
              <a:ext uri="{FF2B5EF4-FFF2-40B4-BE49-F238E27FC236}">
                <a16:creationId xmlns:a16="http://schemas.microsoft.com/office/drawing/2014/main" id="{08C438E4-62A6-CCEF-3F86-92881260B376}"/>
              </a:ext>
            </a:extLst>
          </p:cNvPr>
          <p:cNvSpPr txBox="1"/>
          <p:nvPr/>
        </p:nvSpPr>
        <p:spPr>
          <a:xfrm>
            <a:off x="5286045" y="563634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43" name="CuadroTexto 142">
            <a:extLst>
              <a:ext uri="{FF2B5EF4-FFF2-40B4-BE49-F238E27FC236}">
                <a16:creationId xmlns:a16="http://schemas.microsoft.com/office/drawing/2014/main" id="{D839B493-E7EA-41CB-E13E-960ACDDD037C}"/>
              </a:ext>
            </a:extLst>
          </p:cNvPr>
          <p:cNvSpPr txBox="1"/>
          <p:nvPr/>
        </p:nvSpPr>
        <p:spPr>
          <a:xfrm>
            <a:off x="5388569" y="563911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44" name="CuadroTexto 143">
            <a:extLst>
              <a:ext uri="{FF2B5EF4-FFF2-40B4-BE49-F238E27FC236}">
                <a16:creationId xmlns:a16="http://schemas.microsoft.com/office/drawing/2014/main" id="{D1078C16-9811-D4AF-9914-5F57CA7FC10C}"/>
              </a:ext>
            </a:extLst>
          </p:cNvPr>
          <p:cNvSpPr txBox="1"/>
          <p:nvPr/>
        </p:nvSpPr>
        <p:spPr>
          <a:xfrm>
            <a:off x="6394802" y="448364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45" name="CuadroTexto 144">
            <a:extLst>
              <a:ext uri="{FF2B5EF4-FFF2-40B4-BE49-F238E27FC236}">
                <a16:creationId xmlns:a16="http://schemas.microsoft.com/office/drawing/2014/main" id="{DED08CAC-65AB-54F1-8F02-9BA7C8567411}"/>
              </a:ext>
            </a:extLst>
          </p:cNvPr>
          <p:cNvSpPr txBox="1"/>
          <p:nvPr/>
        </p:nvSpPr>
        <p:spPr>
          <a:xfrm>
            <a:off x="6497326" y="448641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46" name="CuadroTexto 145">
            <a:extLst>
              <a:ext uri="{FF2B5EF4-FFF2-40B4-BE49-F238E27FC236}">
                <a16:creationId xmlns:a16="http://schemas.microsoft.com/office/drawing/2014/main" id="{56E90BB7-6196-3D0C-CA7E-702DB3CE85DA}"/>
              </a:ext>
            </a:extLst>
          </p:cNvPr>
          <p:cNvSpPr txBox="1"/>
          <p:nvPr/>
        </p:nvSpPr>
        <p:spPr>
          <a:xfrm>
            <a:off x="6787930" y="419745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47" name="CuadroTexto 146">
            <a:extLst>
              <a:ext uri="{FF2B5EF4-FFF2-40B4-BE49-F238E27FC236}">
                <a16:creationId xmlns:a16="http://schemas.microsoft.com/office/drawing/2014/main" id="{1E643818-0183-1B72-9685-9055775251F7}"/>
              </a:ext>
            </a:extLst>
          </p:cNvPr>
          <p:cNvSpPr txBox="1"/>
          <p:nvPr/>
        </p:nvSpPr>
        <p:spPr>
          <a:xfrm>
            <a:off x="6890454" y="420022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48" name="CuadroTexto 147">
            <a:extLst>
              <a:ext uri="{FF2B5EF4-FFF2-40B4-BE49-F238E27FC236}">
                <a16:creationId xmlns:a16="http://schemas.microsoft.com/office/drawing/2014/main" id="{520C84F2-6B93-1CC3-98AF-685580A60A38}"/>
              </a:ext>
            </a:extLst>
          </p:cNvPr>
          <p:cNvSpPr txBox="1"/>
          <p:nvPr/>
        </p:nvSpPr>
        <p:spPr>
          <a:xfrm>
            <a:off x="7165562" y="529359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49" name="CuadroTexto 148">
            <a:extLst>
              <a:ext uri="{FF2B5EF4-FFF2-40B4-BE49-F238E27FC236}">
                <a16:creationId xmlns:a16="http://schemas.microsoft.com/office/drawing/2014/main" id="{1D289F2A-F9C7-3C1D-D245-5745F4245E78}"/>
              </a:ext>
            </a:extLst>
          </p:cNvPr>
          <p:cNvSpPr txBox="1"/>
          <p:nvPr/>
        </p:nvSpPr>
        <p:spPr>
          <a:xfrm>
            <a:off x="7268086" y="529636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50" name="CuadroTexto 149">
            <a:extLst>
              <a:ext uri="{FF2B5EF4-FFF2-40B4-BE49-F238E27FC236}">
                <a16:creationId xmlns:a16="http://schemas.microsoft.com/office/drawing/2014/main" id="{DFD13D96-27F6-69DA-3B67-4FAFCF2C254A}"/>
              </a:ext>
            </a:extLst>
          </p:cNvPr>
          <p:cNvSpPr txBox="1"/>
          <p:nvPr/>
        </p:nvSpPr>
        <p:spPr>
          <a:xfrm>
            <a:off x="8337668" y="510497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51" name="CuadroTexto 150">
            <a:extLst>
              <a:ext uri="{FF2B5EF4-FFF2-40B4-BE49-F238E27FC236}">
                <a16:creationId xmlns:a16="http://schemas.microsoft.com/office/drawing/2014/main" id="{A5D2575B-22A7-8CA2-1D86-21CD365FD68E}"/>
              </a:ext>
            </a:extLst>
          </p:cNvPr>
          <p:cNvSpPr txBox="1"/>
          <p:nvPr/>
        </p:nvSpPr>
        <p:spPr>
          <a:xfrm>
            <a:off x="8427802" y="539652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52" name="CuadroTexto 151">
            <a:extLst>
              <a:ext uri="{FF2B5EF4-FFF2-40B4-BE49-F238E27FC236}">
                <a16:creationId xmlns:a16="http://schemas.microsoft.com/office/drawing/2014/main" id="{B7A4DECC-DF81-AAF6-BD6C-1A4A658D0018}"/>
              </a:ext>
            </a:extLst>
          </p:cNvPr>
          <p:cNvSpPr txBox="1"/>
          <p:nvPr/>
        </p:nvSpPr>
        <p:spPr>
          <a:xfrm>
            <a:off x="8699220" y="518359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53" name="CuadroTexto 152">
            <a:extLst>
              <a:ext uri="{FF2B5EF4-FFF2-40B4-BE49-F238E27FC236}">
                <a16:creationId xmlns:a16="http://schemas.microsoft.com/office/drawing/2014/main" id="{CD7A03B6-12AB-CC85-149A-925BB0F964D7}"/>
              </a:ext>
            </a:extLst>
          </p:cNvPr>
          <p:cNvSpPr txBox="1"/>
          <p:nvPr/>
        </p:nvSpPr>
        <p:spPr>
          <a:xfrm>
            <a:off x="8801744" y="518636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54" name="CuadroTexto 153">
            <a:extLst>
              <a:ext uri="{FF2B5EF4-FFF2-40B4-BE49-F238E27FC236}">
                <a16:creationId xmlns:a16="http://schemas.microsoft.com/office/drawing/2014/main" id="{CA115150-D14C-E9C8-D5C0-412469D9E845}"/>
              </a:ext>
            </a:extLst>
          </p:cNvPr>
          <p:cNvSpPr txBox="1"/>
          <p:nvPr/>
        </p:nvSpPr>
        <p:spPr>
          <a:xfrm>
            <a:off x="9080217" y="531937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55" name="CuadroTexto 154">
            <a:extLst>
              <a:ext uri="{FF2B5EF4-FFF2-40B4-BE49-F238E27FC236}">
                <a16:creationId xmlns:a16="http://schemas.microsoft.com/office/drawing/2014/main" id="{3AC988C3-9725-E233-25D5-BD9591D6A6CC}"/>
              </a:ext>
            </a:extLst>
          </p:cNvPr>
          <p:cNvSpPr txBox="1"/>
          <p:nvPr/>
        </p:nvSpPr>
        <p:spPr>
          <a:xfrm>
            <a:off x="9182741" y="532214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56" name="CuadroTexto 155">
            <a:extLst>
              <a:ext uri="{FF2B5EF4-FFF2-40B4-BE49-F238E27FC236}">
                <a16:creationId xmlns:a16="http://schemas.microsoft.com/office/drawing/2014/main" id="{57BD946E-4A42-C0A2-ADB5-AF1B89206277}"/>
              </a:ext>
            </a:extLst>
          </p:cNvPr>
          <p:cNvSpPr txBox="1"/>
          <p:nvPr/>
        </p:nvSpPr>
        <p:spPr>
          <a:xfrm>
            <a:off x="11029331" y="509072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57" name="CuadroTexto 156">
            <a:extLst>
              <a:ext uri="{FF2B5EF4-FFF2-40B4-BE49-F238E27FC236}">
                <a16:creationId xmlns:a16="http://schemas.microsoft.com/office/drawing/2014/main" id="{4A11CEC1-6657-8AE2-5CBE-8186D6C8FC23}"/>
              </a:ext>
            </a:extLst>
          </p:cNvPr>
          <p:cNvSpPr txBox="1"/>
          <p:nvPr/>
        </p:nvSpPr>
        <p:spPr>
          <a:xfrm>
            <a:off x="11131855" y="509349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58" name="CuadroTexto 157">
            <a:extLst>
              <a:ext uri="{FF2B5EF4-FFF2-40B4-BE49-F238E27FC236}">
                <a16:creationId xmlns:a16="http://schemas.microsoft.com/office/drawing/2014/main" id="{68CD4CB6-EFAA-1327-4F7D-4183CE92189A}"/>
              </a:ext>
            </a:extLst>
          </p:cNvPr>
          <p:cNvSpPr txBox="1"/>
          <p:nvPr/>
        </p:nvSpPr>
        <p:spPr>
          <a:xfrm>
            <a:off x="10720595" y="470835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pic>
        <p:nvPicPr>
          <p:cNvPr id="159" name="Imagen 158">
            <a:extLst>
              <a:ext uri="{FF2B5EF4-FFF2-40B4-BE49-F238E27FC236}">
                <a16:creationId xmlns:a16="http://schemas.microsoft.com/office/drawing/2014/main" id="{7E0B5844-F82F-4D72-EF64-B6AB110DC40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73" b="4482"/>
          <a:stretch/>
        </p:blipFill>
        <p:spPr>
          <a:xfrm rot="16200000">
            <a:off x="6199991" y="4826478"/>
            <a:ext cx="2078822" cy="6550619"/>
          </a:xfrm>
          <a:prstGeom prst="rect">
            <a:avLst/>
          </a:prstGeom>
        </p:spPr>
      </p:pic>
      <p:graphicFrame>
        <p:nvGraphicFramePr>
          <p:cNvPr id="160" name="Tabla 8">
            <a:extLst>
              <a:ext uri="{FF2B5EF4-FFF2-40B4-BE49-F238E27FC236}">
                <a16:creationId xmlns:a16="http://schemas.microsoft.com/office/drawing/2014/main" id="{14D4E621-4E43-C2F4-BC20-50CBF46FC9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20121693"/>
              </p:ext>
            </p:extLst>
          </p:nvPr>
        </p:nvGraphicFramePr>
        <p:xfrm>
          <a:off x="2258973" y="7182294"/>
          <a:ext cx="781050" cy="338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0175">
                  <a:extLst>
                    <a:ext uri="{9D8B030D-6E8A-4147-A177-3AD203B41FA5}">
                      <a16:colId xmlns:a16="http://schemas.microsoft.com/office/drawing/2014/main" val="1152800066"/>
                    </a:ext>
                  </a:extLst>
                </a:gridCol>
                <a:gridCol w="130175">
                  <a:extLst>
                    <a:ext uri="{9D8B030D-6E8A-4147-A177-3AD203B41FA5}">
                      <a16:colId xmlns:a16="http://schemas.microsoft.com/office/drawing/2014/main" val="958640047"/>
                    </a:ext>
                  </a:extLst>
                </a:gridCol>
                <a:gridCol w="130175">
                  <a:extLst>
                    <a:ext uri="{9D8B030D-6E8A-4147-A177-3AD203B41FA5}">
                      <a16:colId xmlns:a16="http://schemas.microsoft.com/office/drawing/2014/main" val="1818967799"/>
                    </a:ext>
                  </a:extLst>
                </a:gridCol>
                <a:gridCol w="130175">
                  <a:extLst>
                    <a:ext uri="{9D8B030D-6E8A-4147-A177-3AD203B41FA5}">
                      <a16:colId xmlns:a16="http://schemas.microsoft.com/office/drawing/2014/main" val="977473853"/>
                    </a:ext>
                  </a:extLst>
                </a:gridCol>
                <a:gridCol w="130175">
                  <a:extLst>
                    <a:ext uri="{9D8B030D-6E8A-4147-A177-3AD203B41FA5}">
                      <a16:colId xmlns:a16="http://schemas.microsoft.com/office/drawing/2014/main" val="1404427292"/>
                    </a:ext>
                  </a:extLst>
                </a:gridCol>
                <a:gridCol w="130175">
                  <a:extLst>
                    <a:ext uri="{9D8B030D-6E8A-4147-A177-3AD203B41FA5}">
                      <a16:colId xmlns:a16="http://schemas.microsoft.com/office/drawing/2014/main" val="1929408398"/>
                    </a:ext>
                  </a:extLst>
                </a:gridCol>
              </a:tblGrid>
              <a:tr h="338554">
                <a:tc>
                  <a:txBody>
                    <a:bodyPr/>
                    <a:lstStyle/>
                    <a:p>
                      <a:endParaRPr lang="es-AR" sz="1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es-AR" sz="100" b="1" kern="1200" dirty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es-AR" sz="100" b="1" kern="1200" dirty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es-AR" sz="100" b="1" kern="1200" dirty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s-AR" sz="1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s-AR" sz="1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9170892"/>
                  </a:ext>
                </a:extLst>
              </a:tr>
            </a:tbl>
          </a:graphicData>
        </a:graphic>
      </p:graphicFrame>
      <p:pic>
        <p:nvPicPr>
          <p:cNvPr id="161" name="Gráfico 160">
            <a:extLst>
              <a:ext uri="{FF2B5EF4-FFF2-40B4-BE49-F238E27FC236}">
                <a16:creationId xmlns:a16="http://schemas.microsoft.com/office/drawing/2014/main" id="{B59AD570-61C0-038C-D7A7-66ABE239BF7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 l="1692" t="2009" r="73215" b="77871"/>
          <a:stretch/>
        </p:blipFill>
        <p:spPr>
          <a:xfrm>
            <a:off x="2275356" y="7136573"/>
            <a:ext cx="761957" cy="338554"/>
          </a:xfrm>
          <a:prstGeom prst="rect">
            <a:avLst/>
          </a:prstGeom>
        </p:spPr>
      </p:pic>
      <p:sp>
        <p:nvSpPr>
          <p:cNvPr id="162" name="CuadroTexto 161">
            <a:extLst>
              <a:ext uri="{FF2B5EF4-FFF2-40B4-BE49-F238E27FC236}">
                <a16:creationId xmlns:a16="http://schemas.microsoft.com/office/drawing/2014/main" id="{F7F2620F-E173-3C1B-076F-E0045C974D24}"/>
              </a:ext>
            </a:extLst>
          </p:cNvPr>
          <p:cNvSpPr txBox="1"/>
          <p:nvPr/>
        </p:nvSpPr>
        <p:spPr>
          <a:xfrm>
            <a:off x="2275356" y="6897824"/>
            <a:ext cx="7619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AR" sz="1000" b="1" dirty="0"/>
              <a:t>Color Key</a:t>
            </a:r>
          </a:p>
        </p:txBody>
      </p:sp>
      <p:graphicFrame>
        <p:nvGraphicFramePr>
          <p:cNvPr id="163" name="Tabla 8">
            <a:extLst>
              <a:ext uri="{FF2B5EF4-FFF2-40B4-BE49-F238E27FC236}">
                <a16:creationId xmlns:a16="http://schemas.microsoft.com/office/drawing/2014/main" id="{D24A9729-A8A8-C71D-10A2-0FFBE47451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7038398"/>
              </p:ext>
            </p:extLst>
          </p:nvPr>
        </p:nvGraphicFramePr>
        <p:xfrm>
          <a:off x="2323296" y="7251617"/>
          <a:ext cx="650875" cy="338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0175">
                  <a:extLst>
                    <a:ext uri="{9D8B030D-6E8A-4147-A177-3AD203B41FA5}">
                      <a16:colId xmlns:a16="http://schemas.microsoft.com/office/drawing/2014/main" val="1152800066"/>
                    </a:ext>
                  </a:extLst>
                </a:gridCol>
                <a:gridCol w="130175">
                  <a:extLst>
                    <a:ext uri="{9D8B030D-6E8A-4147-A177-3AD203B41FA5}">
                      <a16:colId xmlns:a16="http://schemas.microsoft.com/office/drawing/2014/main" val="958640047"/>
                    </a:ext>
                  </a:extLst>
                </a:gridCol>
                <a:gridCol w="130175">
                  <a:extLst>
                    <a:ext uri="{9D8B030D-6E8A-4147-A177-3AD203B41FA5}">
                      <a16:colId xmlns:a16="http://schemas.microsoft.com/office/drawing/2014/main" val="1818967799"/>
                    </a:ext>
                  </a:extLst>
                </a:gridCol>
                <a:gridCol w="130175">
                  <a:extLst>
                    <a:ext uri="{9D8B030D-6E8A-4147-A177-3AD203B41FA5}">
                      <a16:colId xmlns:a16="http://schemas.microsoft.com/office/drawing/2014/main" val="977473853"/>
                    </a:ext>
                  </a:extLst>
                </a:gridCol>
                <a:gridCol w="130175">
                  <a:extLst>
                    <a:ext uri="{9D8B030D-6E8A-4147-A177-3AD203B41FA5}">
                      <a16:colId xmlns:a16="http://schemas.microsoft.com/office/drawing/2014/main" val="1929408398"/>
                    </a:ext>
                  </a:extLst>
                </a:gridCol>
              </a:tblGrid>
              <a:tr h="338554">
                <a:tc>
                  <a:txBody>
                    <a:bodyPr/>
                    <a:lstStyle/>
                    <a:p>
                      <a:pPr algn="ctr"/>
                      <a:r>
                        <a:rPr lang="es-AR" sz="400" b="0" dirty="0">
                          <a:solidFill>
                            <a:sysClr val="windowText" lastClr="000000"/>
                          </a:solidFill>
                        </a:rPr>
                        <a:t>-10</a:t>
                      </a: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s-AR" sz="400" b="0" kern="1200" dirty="0">
                          <a:solidFill>
                            <a:sysClr val="windowText" lastClr="000000"/>
                          </a:solidFill>
                          <a:latin typeface="+mn-lt"/>
                          <a:ea typeface="+mn-ea"/>
                          <a:cs typeface="+mn-cs"/>
                        </a:rPr>
                        <a:t>-5</a:t>
                      </a:r>
                    </a:p>
                  </a:txBody>
                  <a:tcPr marL="0" marR="0" marT="0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s-AR" sz="400" b="0" kern="1200" dirty="0">
                          <a:solidFill>
                            <a:sysClr val="windowText" lastClr="000000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0" marR="0" marT="0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s-AR" sz="400" b="0" kern="1200" dirty="0">
                          <a:solidFill>
                            <a:sysClr val="windowText" lastClr="000000"/>
                          </a:solidFill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</a:p>
                  </a:txBody>
                  <a:tcPr marL="0" marR="0" marT="0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AR" sz="400" b="0" dirty="0">
                          <a:solidFill>
                            <a:sysClr val="windowText" lastClr="000000"/>
                          </a:solidFill>
                        </a:rPr>
                        <a:t>10</a:t>
                      </a:r>
                    </a:p>
                  </a:txBody>
                  <a:tcPr marL="0" marR="0" marT="0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9170892"/>
                  </a:ext>
                </a:extLst>
              </a:tr>
            </a:tbl>
          </a:graphicData>
        </a:graphic>
      </p:graphicFrame>
      <p:sp>
        <p:nvSpPr>
          <p:cNvPr id="164" name="CuadroTexto 163">
            <a:extLst>
              <a:ext uri="{FF2B5EF4-FFF2-40B4-BE49-F238E27FC236}">
                <a16:creationId xmlns:a16="http://schemas.microsoft.com/office/drawing/2014/main" id="{865561B4-ECDD-412B-AB16-E0919AB4346C}"/>
              </a:ext>
            </a:extLst>
          </p:cNvPr>
          <p:cNvSpPr txBox="1"/>
          <p:nvPr/>
        </p:nvSpPr>
        <p:spPr>
          <a:xfrm>
            <a:off x="2275355" y="7534290"/>
            <a:ext cx="7619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AR" sz="700" b="1" dirty="0" err="1"/>
              <a:t>value</a:t>
            </a:r>
            <a:endParaRPr lang="es-AR" sz="700" b="1" dirty="0"/>
          </a:p>
        </p:txBody>
      </p:sp>
      <p:graphicFrame>
        <p:nvGraphicFramePr>
          <p:cNvPr id="165" name="Gráfico 164">
            <a:extLst>
              <a:ext uri="{FF2B5EF4-FFF2-40B4-BE49-F238E27FC236}">
                <a16:creationId xmlns:a16="http://schemas.microsoft.com/office/drawing/2014/main" id="{BF997C3F-299D-F905-8752-FD89D9D38A6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7767144"/>
              </p:ext>
            </p:extLst>
          </p:nvPr>
        </p:nvGraphicFramePr>
        <p:xfrm>
          <a:off x="3052295" y="9509159"/>
          <a:ext cx="8226534" cy="28088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pSp>
        <p:nvGrpSpPr>
          <p:cNvPr id="166" name="Grupo 165">
            <a:extLst>
              <a:ext uri="{FF2B5EF4-FFF2-40B4-BE49-F238E27FC236}">
                <a16:creationId xmlns:a16="http://schemas.microsoft.com/office/drawing/2014/main" id="{CA42AF2B-ABD2-6ED0-0132-5C488FE45B31}"/>
              </a:ext>
            </a:extLst>
          </p:cNvPr>
          <p:cNvGrpSpPr/>
          <p:nvPr/>
        </p:nvGrpSpPr>
        <p:grpSpPr>
          <a:xfrm>
            <a:off x="10700126" y="8656627"/>
            <a:ext cx="1493367" cy="288147"/>
            <a:chOff x="9485219" y="1622455"/>
            <a:chExt cx="1493367" cy="288147"/>
          </a:xfrm>
        </p:grpSpPr>
        <p:sp>
          <p:nvSpPr>
            <p:cNvPr id="167" name="CuadroTexto 166">
              <a:extLst>
                <a:ext uri="{FF2B5EF4-FFF2-40B4-BE49-F238E27FC236}">
                  <a16:creationId xmlns:a16="http://schemas.microsoft.com/office/drawing/2014/main" id="{746F9F49-71B3-9EAE-8B3C-CBE57858A05E}"/>
                </a:ext>
              </a:extLst>
            </p:cNvPr>
            <p:cNvSpPr txBox="1"/>
            <p:nvPr/>
          </p:nvSpPr>
          <p:spPr>
            <a:xfrm>
              <a:off x="9485219" y="1622455"/>
              <a:ext cx="1189292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ct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PS</a:t>
              </a:r>
            </a:p>
          </p:txBody>
        </p:sp>
        <p:sp>
          <p:nvSpPr>
            <p:cNvPr id="168" name="Rectángulo 167">
              <a:extLst>
                <a:ext uri="{FF2B5EF4-FFF2-40B4-BE49-F238E27FC236}">
                  <a16:creationId xmlns:a16="http://schemas.microsoft.com/office/drawing/2014/main" id="{F10ABDAE-1224-A95A-963F-D0C3C2C3E629}"/>
                </a:ext>
              </a:extLst>
            </p:cNvPr>
            <p:cNvSpPr/>
            <p:nvPr/>
          </p:nvSpPr>
          <p:spPr>
            <a:xfrm>
              <a:off x="10756416" y="1671463"/>
              <a:ext cx="222170" cy="199555"/>
            </a:xfrm>
            <a:prstGeom prst="rect">
              <a:avLst/>
            </a:prstGeom>
            <a:solidFill>
              <a:srgbClr val="D99694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</p:grpSp>
      <p:grpSp>
        <p:nvGrpSpPr>
          <p:cNvPr id="169" name="Grupo 168">
            <a:extLst>
              <a:ext uri="{FF2B5EF4-FFF2-40B4-BE49-F238E27FC236}">
                <a16:creationId xmlns:a16="http://schemas.microsoft.com/office/drawing/2014/main" id="{D2401EE8-B421-F283-8786-DCE718FAEF2B}"/>
              </a:ext>
            </a:extLst>
          </p:cNvPr>
          <p:cNvGrpSpPr/>
          <p:nvPr/>
        </p:nvGrpSpPr>
        <p:grpSpPr>
          <a:xfrm>
            <a:off x="10701793" y="8172325"/>
            <a:ext cx="1490275" cy="288147"/>
            <a:chOff x="9486199" y="2104597"/>
            <a:chExt cx="1490275" cy="288147"/>
          </a:xfrm>
        </p:grpSpPr>
        <p:sp>
          <p:nvSpPr>
            <p:cNvPr id="170" name="CuadroTexto 169">
              <a:extLst>
                <a:ext uri="{FF2B5EF4-FFF2-40B4-BE49-F238E27FC236}">
                  <a16:creationId xmlns:a16="http://schemas.microsoft.com/office/drawing/2014/main" id="{481EC0E8-472A-28BD-E0C2-D0B70D569623}"/>
                </a:ext>
              </a:extLst>
            </p:cNvPr>
            <p:cNvSpPr txBox="1"/>
            <p:nvPr/>
          </p:nvSpPr>
          <p:spPr>
            <a:xfrm>
              <a:off x="9486199" y="2104597"/>
              <a:ext cx="1188311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ct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3 + LPS</a:t>
              </a:r>
            </a:p>
          </p:txBody>
        </p:sp>
        <p:sp>
          <p:nvSpPr>
            <p:cNvPr id="171" name="Rectángulo 170">
              <a:extLst>
                <a:ext uri="{FF2B5EF4-FFF2-40B4-BE49-F238E27FC236}">
                  <a16:creationId xmlns:a16="http://schemas.microsoft.com/office/drawing/2014/main" id="{1D9FA461-0DC2-F341-4F36-9148EAA7E095}"/>
                </a:ext>
              </a:extLst>
            </p:cNvPr>
            <p:cNvSpPr/>
            <p:nvPr/>
          </p:nvSpPr>
          <p:spPr>
            <a:xfrm>
              <a:off x="10754304" y="2107890"/>
              <a:ext cx="222170" cy="199555"/>
            </a:xfrm>
            <a:prstGeom prst="rect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</p:grpSp>
      <p:grpSp>
        <p:nvGrpSpPr>
          <p:cNvPr id="172" name="Grupo 171">
            <a:extLst>
              <a:ext uri="{FF2B5EF4-FFF2-40B4-BE49-F238E27FC236}">
                <a16:creationId xmlns:a16="http://schemas.microsoft.com/office/drawing/2014/main" id="{7BBCFE77-60E1-E326-0315-F05AEED50C2E}"/>
              </a:ext>
            </a:extLst>
          </p:cNvPr>
          <p:cNvGrpSpPr/>
          <p:nvPr/>
        </p:nvGrpSpPr>
        <p:grpSpPr>
          <a:xfrm>
            <a:off x="10700399" y="7718216"/>
            <a:ext cx="1499013" cy="288147"/>
            <a:chOff x="9479573" y="2583677"/>
            <a:chExt cx="1499013" cy="288147"/>
          </a:xfrm>
        </p:grpSpPr>
        <p:sp>
          <p:nvSpPr>
            <p:cNvPr id="173" name="CuadroTexto 172">
              <a:extLst>
                <a:ext uri="{FF2B5EF4-FFF2-40B4-BE49-F238E27FC236}">
                  <a16:creationId xmlns:a16="http://schemas.microsoft.com/office/drawing/2014/main" id="{28BB876B-8162-DBB4-77EC-3F63D25A9C1C}"/>
                </a:ext>
              </a:extLst>
            </p:cNvPr>
            <p:cNvSpPr txBox="1"/>
            <p:nvPr/>
          </p:nvSpPr>
          <p:spPr>
            <a:xfrm>
              <a:off x="9479573" y="2583677"/>
              <a:ext cx="1190523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ct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1 + LPS</a:t>
              </a:r>
            </a:p>
          </p:txBody>
        </p:sp>
        <p:sp>
          <p:nvSpPr>
            <p:cNvPr id="174" name="Rectángulo 173">
              <a:extLst>
                <a:ext uri="{FF2B5EF4-FFF2-40B4-BE49-F238E27FC236}">
                  <a16:creationId xmlns:a16="http://schemas.microsoft.com/office/drawing/2014/main" id="{733FFA2E-206A-B6AE-9A60-995A9378760D}"/>
                </a:ext>
              </a:extLst>
            </p:cNvPr>
            <p:cNvSpPr/>
            <p:nvPr/>
          </p:nvSpPr>
          <p:spPr>
            <a:xfrm>
              <a:off x="10756416" y="2599155"/>
              <a:ext cx="222170" cy="199555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</p:grpSp>
      <p:sp>
        <p:nvSpPr>
          <p:cNvPr id="175" name="テキスト ボックス 27">
            <a:extLst>
              <a:ext uri="{FF2B5EF4-FFF2-40B4-BE49-F238E27FC236}">
                <a16:creationId xmlns:a16="http://schemas.microsoft.com/office/drawing/2014/main" id="{793D9395-C987-2ED0-35A4-177495BB87F5}"/>
              </a:ext>
            </a:extLst>
          </p:cNvPr>
          <p:cNvSpPr txBox="1"/>
          <p:nvPr/>
        </p:nvSpPr>
        <p:spPr>
          <a:xfrm rot="16200000">
            <a:off x="1555171" y="10525141"/>
            <a:ext cx="1994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ld</a:t>
            </a:r>
            <a:r>
              <a:rPr lang="es-A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A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nges</a:t>
            </a:r>
            <a:r>
              <a:rPr lang="es-A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og</a:t>
            </a:r>
            <a:r>
              <a:rPr lang="es-A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A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tio)</a:t>
            </a:r>
            <a:endParaRPr kumimoji="1" lang="ja-JP" altLang="en-US" sz="1400" dirty="0">
              <a:latin typeface="Times New Roman" panose="02020603050405020304" pitchFamily="18" charset="0"/>
              <a:ea typeface="Meiryo UI" pitchFamily="50" charset="-128"/>
              <a:cs typeface="Times New Roman" pitchFamily="18" charset="0"/>
            </a:endParaRPr>
          </a:p>
        </p:txBody>
      </p:sp>
      <p:grpSp>
        <p:nvGrpSpPr>
          <p:cNvPr id="176" name="Grupo 175">
            <a:extLst>
              <a:ext uri="{FF2B5EF4-FFF2-40B4-BE49-F238E27FC236}">
                <a16:creationId xmlns:a16="http://schemas.microsoft.com/office/drawing/2014/main" id="{FE621A5D-A413-A07C-791A-282672E2FA1A}"/>
              </a:ext>
            </a:extLst>
          </p:cNvPr>
          <p:cNvGrpSpPr/>
          <p:nvPr/>
        </p:nvGrpSpPr>
        <p:grpSpPr>
          <a:xfrm>
            <a:off x="3420037" y="12076564"/>
            <a:ext cx="8146917" cy="1025182"/>
            <a:chOff x="2615750" y="5825679"/>
            <a:chExt cx="8146917" cy="1025182"/>
          </a:xfrm>
        </p:grpSpPr>
        <p:sp>
          <p:nvSpPr>
            <p:cNvPr id="177" name="Rectángulo 176">
              <a:extLst>
                <a:ext uri="{FF2B5EF4-FFF2-40B4-BE49-F238E27FC236}">
                  <a16:creationId xmlns:a16="http://schemas.microsoft.com/office/drawing/2014/main" id="{117A3F02-A6AB-9CCB-7870-A7BACCAB9984}"/>
                </a:ext>
              </a:extLst>
            </p:cNvPr>
            <p:cNvSpPr/>
            <p:nvPr/>
          </p:nvSpPr>
          <p:spPr>
            <a:xfrm>
              <a:off x="2716888" y="5842190"/>
              <a:ext cx="8045779" cy="21858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  <p:sp>
          <p:nvSpPr>
            <p:cNvPr id="178" name="Rectángulo 177">
              <a:extLst>
                <a:ext uri="{FF2B5EF4-FFF2-40B4-BE49-F238E27FC236}">
                  <a16:creationId xmlns:a16="http://schemas.microsoft.com/office/drawing/2014/main" id="{85FCCD3C-9658-6FCF-B622-A7EE49F22F5C}"/>
                </a:ext>
              </a:extLst>
            </p:cNvPr>
            <p:cNvSpPr/>
            <p:nvPr/>
          </p:nvSpPr>
          <p:spPr>
            <a:xfrm>
              <a:off x="8648806" y="6773786"/>
              <a:ext cx="1338317" cy="770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  <p:sp>
          <p:nvSpPr>
            <p:cNvPr id="179" name="CuadroTexto 178">
              <a:extLst>
                <a:ext uri="{FF2B5EF4-FFF2-40B4-BE49-F238E27FC236}">
                  <a16:creationId xmlns:a16="http://schemas.microsoft.com/office/drawing/2014/main" id="{78B57869-4FC5-C5AA-14C7-1CCB3DC69727}"/>
                </a:ext>
              </a:extLst>
            </p:cNvPr>
            <p:cNvSpPr txBox="1"/>
            <p:nvPr/>
          </p:nvSpPr>
          <p:spPr>
            <a:xfrm rot="16200000">
              <a:off x="2414824" y="6051335"/>
              <a:ext cx="689999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HX58</a:t>
              </a:r>
            </a:p>
          </p:txBody>
        </p:sp>
        <p:sp>
          <p:nvSpPr>
            <p:cNvPr id="180" name="CuadroTexto 179">
              <a:extLst>
                <a:ext uri="{FF2B5EF4-FFF2-40B4-BE49-F238E27FC236}">
                  <a16:creationId xmlns:a16="http://schemas.microsoft.com/office/drawing/2014/main" id="{6D82B178-DD35-C599-F8A2-1A5BA8D1107E}"/>
                </a:ext>
              </a:extLst>
            </p:cNvPr>
            <p:cNvSpPr txBox="1"/>
            <p:nvPr/>
          </p:nvSpPr>
          <p:spPr>
            <a:xfrm rot="16200000">
              <a:off x="2766307" y="6095936"/>
              <a:ext cx="783177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I209</a:t>
              </a:r>
            </a:p>
          </p:txBody>
        </p:sp>
        <p:sp>
          <p:nvSpPr>
            <p:cNvPr id="181" name="CuadroTexto 180">
              <a:extLst>
                <a:ext uri="{FF2B5EF4-FFF2-40B4-BE49-F238E27FC236}">
                  <a16:creationId xmlns:a16="http://schemas.microsoft.com/office/drawing/2014/main" id="{C59A0B7A-DC38-B1F8-1329-0A183D72769C}"/>
                </a:ext>
              </a:extLst>
            </p:cNvPr>
            <p:cNvSpPr txBox="1"/>
            <p:nvPr/>
          </p:nvSpPr>
          <p:spPr>
            <a:xfrm rot="16200000">
              <a:off x="3101047" y="6133629"/>
              <a:ext cx="854588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I213</a:t>
              </a:r>
            </a:p>
          </p:txBody>
        </p:sp>
        <p:sp>
          <p:nvSpPr>
            <p:cNvPr id="182" name="CuadroTexto 181">
              <a:extLst>
                <a:ext uri="{FF2B5EF4-FFF2-40B4-BE49-F238E27FC236}">
                  <a16:creationId xmlns:a16="http://schemas.microsoft.com/office/drawing/2014/main" id="{E491CDAC-C926-E80C-E2BB-4D4E8E0AD3D5}"/>
                </a:ext>
              </a:extLst>
            </p:cNvPr>
            <p:cNvSpPr txBox="1"/>
            <p:nvPr/>
          </p:nvSpPr>
          <p:spPr>
            <a:xfrm rot="16200000">
              <a:off x="3495335" y="6131640"/>
              <a:ext cx="854589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IT1b11</a:t>
              </a:r>
            </a:p>
          </p:txBody>
        </p:sp>
        <p:sp>
          <p:nvSpPr>
            <p:cNvPr id="183" name="CuadroTexto 182">
              <a:extLst>
                <a:ext uri="{FF2B5EF4-FFF2-40B4-BE49-F238E27FC236}">
                  <a16:creationId xmlns:a16="http://schemas.microsoft.com/office/drawing/2014/main" id="{1A4D0014-1CA9-1295-B15E-860BDAA0A58C}"/>
                </a:ext>
              </a:extLst>
            </p:cNvPr>
            <p:cNvSpPr txBox="1"/>
            <p:nvPr/>
          </p:nvSpPr>
          <p:spPr>
            <a:xfrm rot="16200000">
              <a:off x="3990907" y="6096930"/>
              <a:ext cx="781189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IT3</a:t>
              </a:r>
            </a:p>
          </p:txBody>
        </p:sp>
        <p:sp>
          <p:nvSpPr>
            <p:cNvPr id="184" name="CuadroTexto 183">
              <a:extLst>
                <a:ext uri="{FF2B5EF4-FFF2-40B4-BE49-F238E27FC236}">
                  <a16:creationId xmlns:a16="http://schemas.microsoft.com/office/drawing/2014/main" id="{043B5CB2-739E-A78D-311A-DEC5711882F7}"/>
                </a:ext>
              </a:extLst>
            </p:cNvPr>
            <p:cNvSpPr txBox="1"/>
            <p:nvPr/>
          </p:nvSpPr>
          <p:spPr>
            <a:xfrm rot="16200000">
              <a:off x="4418763" y="6020160"/>
              <a:ext cx="677109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IT3b</a:t>
              </a:r>
            </a:p>
          </p:txBody>
        </p:sp>
        <p:sp>
          <p:nvSpPr>
            <p:cNvPr id="185" name="CuadroTexto 184">
              <a:extLst>
                <a:ext uri="{FF2B5EF4-FFF2-40B4-BE49-F238E27FC236}">
                  <a16:creationId xmlns:a16="http://schemas.microsoft.com/office/drawing/2014/main" id="{CBA4CEA8-5555-CA76-A508-04E3C449D48D}"/>
                </a:ext>
              </a:extLst>
            </p:cNvPr>
            <p:cNvSpPr txBox="1"/>
            <p:nvPr/>
          </p:nvSpPr>
          <p:spPr>
            <a:xfrm rot="16200000">
              <a:off x="4816599" y="6079842"/>
              <a:ext cx="781190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ITM7</a:t>
              </a:r>
            </a:p>
          </p:txBody>
        </p:sp>
        <p:sp>
          <p:nvSpPr>
            <p:cNvPr id="186" name="CuadroTexto 185">
              <a:extLst>
                <a:ext uri="{FF2B5EF4-FFF2-40B4-BE49-F238E27FC236}">
                  <a16:creationId xmlns:a16="http://schemas.microsoft.com/office/drawing/2014/main" id="{77A7AAB7-007C-8F6F-8A43-A2A87DC697FE}"/>
                </a:ext>
              </a:extLst>
            </p:cNvPr>
            <p:cNvSpPr txBox="1"/>
            <p:nvPr/>
          </p:nvSpPr>
          <p:spPr>
            <a:xfrm rot="16200000">
              <a:off x="5279415" y="6022637"/>
              <a:ext cx="617430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A1</a:t>
              </a:r>
            </a:p>
          </p:txBody>
        </p:sp>
        <p:sp>
          <p:nvSpPr>
            <p:cNvPr id="188" name="CuadroTexto 187">
              <a:extLst>
                <a:ext uri="{FF2B5EF4-FFF2-40B4-BE49-F238E27FC236}">
                  <a16:creationId xmlns:a16="http://schemas.microsoft.com/office/drawing/2014/main" id="{CC44FFB8-8D5E-CFB1-B522-FB9EE9B1CA86}"/>
                </a:ext>
              </a:extLst>
            </p:cNvPr>
            <p:cNvSpPr txBox="1"/>
            <p:nvPr/>
          </p:nvSpPr>
          <p:spPr>
            <a:xfrm rot="16200000">
              <a:off x="5614034" y="6099900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A13</a:t>
              </a:r>
            </a:p>
          </p:txBody>
        </p:sp>
        <p:sp>
          <p:nvSpPr>
            <p:cNvPr id="189" name="CuadroTexto 188">
              <a:extLst>
                <a:ext uri="{FF2B5EF4-FFF2-40B4-BE49-F238E27FC236}">
                  <a16:creationId xmlns:a16="http://schemas.microsoft.com/office/drawing/2014/main" id="{0ADDE9E1-349D-EF94-406F-60E5229BAB83}"/>
                </a:ext>
              </a:extLst>
            </p:cNvPr>
            <p:cNvSpPr txBox="1"/>
            <p:nvPr/>
          </p:nvSpPr>
          <p:spPr>
            <a:xfrm rot="16200000">
              <a:off x="6042539" y="6073722"/>
              <a:ext cx="751211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A14</a:t>
              </a:r>
            </a:p>
          </p:txBody>
        </p:sp>
        <p:sp>
          <p:nvSpPr>
            <p:cNvPr id="190" name="CuadroTexto 189">
              <a:extLst>
                <a:ext uri="{FF2B5EF4-FFF2-40B4-BE49-F238E27FC236}">
                  <a16:creationId xmlns:a16="http://schemas.microsoft.com/office/drawing/2014/main" id="{5A454DEC-43A4-2770-841E-9C00E6771D37}"/>
                </a:ext>
              </a:extLst>
            </p:cNvPr>
            <p:cNvSpPr txBox="1"/>
            <p:nvPr/>
          </p:nvSpPr>
          <p:spPr>
            <a:xfrm rot="16200000">
              <a:off x="6485246" y="6027938"/>
              <a:ext cx="617430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A2</a:t>
              </a:r>
            </a:p>
          </p:txBody>
        </p:sp>
        <p:sp>
          <p:nvSpPr>
            <p:cNvPr id="191" name="CuadroTexto 190">
              <a:extLst>
                <a:ext uri="{FF2B5EF4-FFF2-40B4-BE49-F238E27FC236}">
                  <a16:creationId xmlns:a16="http://schemas.microsoft.com/office/drawing/2014/main" id="{60A8EB4E-7F21-F160-08C2-84801554F23C}"/>
                </a:ext>
              </a:extLst>
            </p:cNvPr>
            <p:cNvSpPr txBox="1"/>
            <p:nvPr/>
          </p:nvSpPr>
          <p:spPr>
            <a:xfrm rot="16200000">
              <a:off x="6911627" y="6020161"/>
              <a:ext cx="617430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A5</a:t>
              </a:r>
            </a:p>
          </p:txBody>
        </p:sp>
        <p:sp>
          <p:nvSpPr>
            <p:cNvPr id="192" name="CuadroTexto 191">
              <a:extLst>
                <a:ext uri="{FF2B5EF4-FFF2-40B4-BE49-F238E27FC236}">
                  <a16:creationId xmlns:a16="http://schemas.microsoft.com/office/drawing/2014/main" id="{AA6F842A-BE9B-A065-C550-68F3CF010B03}"/>
                </a:ext>
              </a:extLst>
            </p:cNvPr>
            <p:cNvSpPr txBox="1"/>
            <p:nvPr/>
          </p:nvSpPr>
          <p:spPr>
            <a:xfrm rot="16200000">
              <a:off x="7252372" y="6098250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A7</a:t>
              </a:r>
            </a:p>
          </p:txBody>
        </p:sp>
        <p:sp>
          <p:nvSpPr>
            <p:cNvPr id="193" name="CuadroTexto 192">
              <a:extLst>
                <a:ext uri="{FF2B5EF4-FFF2-40B4-BE49-F238E27FC236}">
                  <a16:creationId xmlns:a16="http://schemas.microsoft.com/office/drawing/2014/main" id="{F4B395AD-6703-B490-F767-424CD065C0A6}"/>
                </a:ext>
              </a:extLst>
            </p:cNvPr>
            <p:cNvSpPr txBox="1"/>
            <p:nvPr/>
          </p:nvSpPr>
          <p:spPr>
            <a:xfrm rot="16200000">
              <a:off x="7612074" y="6106848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AB</a:t>
              </a:r>
            </a:p>
          </p:txBody>
        </p:sp>
        <p:sp>
          <p:nvSpPr>
            <p:cNvPr id="194" name="CuadroTexto 193">
              <a:extLst>
                <a:ext uri="{FF2B5EF4-FFF2-40B4-BE49-F238E27FC236}">
                  <a16:creationId xmlns:a16="http://schemas.microsoft.com/office/drawing/2014/main" id="{888C85E5-DE7D-DA9E-1856-683CFE1850C9}"/>
                </a:ext>
              </a:extLst>
            </p:cNvPr>
            <p:cNvSpPr txBox="1"/>
            <p:nvPr/>
          </p:nvSpPr>
          <p:spPr>
            <a:xfrm rot="16200000">
              <a:off x="8055281" y="6092657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B1</a:t>
              </a:r>
            </a:p>
          </p:txBody>
        </p:sp>
        <p:sp>
          <p:nvSpPr>
            <p:cNvPr id="195" name="CuadroTexto 194">
              <a:extLst>
                <a:ext uri="{FF2B5EF4-FFF2-40B4-BE49-F238E27FC236}">
                  <a16:creationId xmlns:a16="http://schemas.microsoft.com/office/drawing/2014/main" id="{EDEE2F12-D806-0E74-E630-5FC721AE0E6A}"/>
                </a:ext>
              </a:extLst>
            </p:cNvPr>
            <p:cNvSpPr txBox="1"/>
            <p:nvPr/>
          </p:nvSpPr>
          <p:spPr>
            <a:xfrm rot="16200000">
              <a:off x="8470722" y="6099901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RD1</a:t>
              </a:r>
            </a:p>
          </p:txBody>
        </p:sp>
        <p:sp>
          <p:nvSpPr>
            <p:cNvPr id="196" name="CuadroTexto 195">
              <a:extLst>
                <a:ext uri="{FF2B5EF4-FFF2-40B4-BE49-F238E27FC236}">
                  <a16:creationId xmlns:a16="http://schemas.microsoft.com/office/drawing/2014/main" id="{AED7284A-929B-B1E7-8904-FDC6D9C1333B}"/>
                </a:ext>
              </a:extLst>
            </p:cNvPr>
            <p:cNvSpPr txBox="1"/>
            <p:nvPr/>
          </p:nvSpPr>
          <p:spPr>
            <a:xfrm rot="16200000">
              <a:off x="8873405" y="6106847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AS1a</a:t>
              </a:r>
            </a:p>
          </p:txBody>
        </p:sp>
        <p:sp>
          <p:nvSpPr>
            <p:cNvPr id="197" name="CuadroTexto 196">
              <a:extLst>
                <a:ext uri="{FF2B5EF4-FFF2-40B4-BE49-F238E27FC236}">
                  <a16:creationId xmlns:a16="http://schemas.microsoft.com/office/drawing/2014/main" id="{49284C29-8997-214A-E70F-E3FA39EDD285}"/>
                </a:ext>
              </a:extLst>
            </p:cNvPr>
            <p:cNvSpPr txBox="1"/>
            <p:nvPr/>
          </p:nvSpPr>
          <p:spPr>
            <a:xfrm rot="16200000">
              <a:off x="9302721" y="6100962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AS2</a:t>
              </a:r>
            </a:p>
          </p:txBody>
        </p:sp>
        <p:sp>
          <p:nvSpPr>
            <p:cNvPr id="198" name="CuadroTexto 197">
              <a:extLst>
                <a:ext uri="{FF2B5EF4-FFF2-40B4-BE49-F238E27FC236}">
                  <a16:creationId xmlns:a16="http://schemas.microsoft.com/office/drawing/2014/main" id="{0C99A06A-CD79-AA9B-0625-567DAB1951F0}"/>
                </a:ext>
              </a:extLst>
            </p:cNvPr>
            <p:cNvSpPr txBox="1"/>
            <p:nvPr/>
          </p:nvSpPr>
          <p:spPr>
            <a:xfrm rot="16200000">
              <a:off x="9686848" y="6090586"/>
              <a:ext cx="761354" cy="2881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pPr algn="r"/>
              <a:r>
                <a:rPr lang="es-A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AS3</a:t>
              </a:r>
            </a:p>
          </p:txBody>
        </p:sp>
      </p:grpSp>
      <p:sp>
        <p:nvSpPr>
          <p:cNvPr id="200" name="CuadroTexto 199">
            <a:extLst>
              <a:ext uri="{FF2B5EF4-FFF2-40B4-BE49-F238E27FC236}">
                <a16:creationId xmlns:a16="http://schemas.microsoft.com/office/drawing/2014/main" id="{6F903396-7F9B-F143-26C6-A34D655CEA5D}"/>
              </a:ext>
            </a:extLst>
          </p:cNvPr>
          <p:cNvSpPr txBox="1"/>
          <p:nvPr/>
        </p:nvSpPr>
        <p:spPr>
          <a:xfrm>
            <a:off x="4280762" y="1126353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01" name="CuadroTexto 200">
            <a:extLst>
              <a:ext uri="{FF2B5EF4-FFF2-40B4-BE49-F238E27FC236}">
                <a16:creationId xmlns:a16="http://schemas.microsoft.com/office/drawing/2014/main" id="{17051A85-F890-0FDD-D31D-497696168153}"/>
              </a:ext>
            </a:extLst>
          </p:cNvPr>
          <p:cNvSpPr txBox="1"/>
          <p:nvPr/>
        </p:nvSpPr>
        <p:spPr>
          <a:xfrm>
            <a:off x="4388006" y="1120144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02" name="CuadroTexto 201">
            <a:extLst>
              <a:ext uri="{FF2B5EF4-FFF2-40B4-BE49-F238E27FC236}">
                <a16:creationId xmlns:a16="http://schemas.microsoft.com/office/drawing/2014/main" id="{4464D20B-F89F-C188-C483-C3D5A8D0A04F}"/>
              </a:ext>
            </a:extLst>
          </p:cNvPr>
          <p:cNvSpPr txBox="1"/>
          <p:nvPr/>
        </p:nvSpPr>
        <p:spPr>
          <a:xfrm>
            <a:off x="4701926" y="1072838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03" name="CuadroTexto 202">
            <a:extLst>
              <a:ext uri="{FF2B5EF4-FFF2-40B4-BE49-F238E27FC236}">
                <a16:creationId xmlns:a16="http://schemas.microsoft.com/office/drawing/2014/main" id="{13C7EFE5-769E-0B4F-0DBE-E3316D3541CE}"/>
              </a:ext>
            </a:extLst>
          </p:cNvPr>
          <p:cNvSpPr txBox="1"/>
          <p:nvPr/>
        </p:nvSpPr>
        <p:spPr>
          <a:xfrm>
            <a:off x="4812933" y="1072650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04" name="CuadroTexto 203">
            <a:extLst>
              <a:ext uri="{FF2B5EF4-FFF2-40B4-BE49-F238E27FC236}">
                <a16:creationId xmlns:a16="http://schemas.microsoft.com/office/drawing/2014/main" id="{01FFA82E-BDC4-36B2-A8E0-07D11C969833}"/>
              </a:ext>
            </a:extLst>
          </p:cNvPr>
          <p:cNvSpPr txBox="1"/>
          <p:nvPr/>
        </p:nvSpPr>
        <p:spPr>
          <a:xfrm>
            <a:off x="5089064" y="1012796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05" name="CuadroTexto 204">
            <a:extLst>
              <a:ext uri="{FF2B5EF4-FFF2-40B4-BE49-F238E27FC236}">
                <a16:creationId xmlns:a16="http://schemas.microsoft.com/office/drawing/2014/main" id="{BE4A63FB-46AB-F77B-ED82-7FD66FFDCA6A}"/>
              </a:ext>
            </a:extLst>
          </p:cNvPr>
          <p:cNvSpPr txBox="1"/>
          <p:nvPr/>
        </p:nvSpPr>
        <p:spPr>
          <a:xfrm>
            <a:off x="5200071" y="1012608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06" name="CuadroTexto 205">
            <a:extLst>
              <a:ext uri="{FF2B5EF4-FFF2-40B4-BE49-F238E27FC236}">
                <a16:creationId xmlns:a16="http://schemas.microsoft.com/office/drawing/2014/main" id="{32122084-CC70-8DB1-148C-E7DAC7EC853E}"/>
              </a:ext>
            </a:extLst>
          </p:cNvPr>
          <p:cNvSpPr txBox="1"/>
          <p:nvPr/>
        </p:nvSpPr>
        <p:spPr>
          <a:xfrm>
            <a:off x="5511852" y="1016207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07" name="CuadroTexto 206">
            <a:extLst>
              <a:ext uri="{FF2B5EF4-FFF2-40B4-BE49-F238E27FC236}">
                <a16:creationId xmlns:a16="http://schemas.microsoft.com/office/drawing/2014/main" id="{6E0707FC-4341-069E-E97F-5D2355E569BE}"/>
              </a:ext>
            </a:extLst>
          </p:cNvPr>
          <p:cNvSpPr txBox="1"/>
          <p:nvPr/>
        </p:nvSpPr>
        <p:spPr>
          <a:xfrm>
            <a:off x="5622859" y="1016019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08" name="CuadroTexto 207">
            <a:extLst>
              <a:ext uri="{FF2B5EF4-FFF2-40B4-BE49-F238E27FC236}">
                <a16:creationId xmlns:a16="http://schemas.microsoft.com/office/drawing/2014/main" id="{F2D02766-65BF-FD4B-9904-1B6C254396A6}"/>
              </a:ext>
            </a:extLst>
          </p:cNvPr>
          <p:cNvSpPr txBox="1"/>
          <p:nvPr/>
        </p:nvSpPr>
        <p:spPr>
          <a:xfrm>
            <a:off x="5918332" y="1166181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09" name="CuadroTexto 208">
            <a:extLst>
              <a:ext uri="{FF2B5EF4-FFF2-40B4-BE49-F238E27FC236}">
                <a16:creationId xmlns:a16="http://schemas.microsoft.com/office/drawing/2014/main" id="{183218F8-202B-6141-05C5-FABF8B88833D}"/>
              </a:ext>
            </a:extLst>
          </p:cNvPr>
          <p:cNvSpPr txBox="1"/>
          <p:nvPr/>
        </p:nvSpPr>
        <p:spPr>
          <a:xfrm>
            <a:off x="6029339" y="1165992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10" name="CuadroTexto 209">
            <a:extLst>
              <a:ext uri="{FF2B5EF4-FFF2-40B4-BE49-F238E27FC236}">
                <a16:creationId xmlns:a16="http://schemas.microsoft.com/office/drawing/2014/main" id="{A1AA82A3-07CB-0AEB-9E05-9B3520CE9883}"/>
              </a:ext>
            </a:extLst>
          </p:cNvPr>
          <p:cNvSpPr txBox="1"/>
          <p:nvPr/>
        </p:nvSpPr>
        <p:spPr>
          <a:xfrm>
            <a:off x="6311833" y="1148846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11" name="CuadroTexto 210">
            <a:extLst>
              <a:ext uri="{FF2B5EF4-FFF2-40B4-BE49-F238E27FC236}">
                <a16:creationId xmlns:a16="http://schemas.microsoft.com/office/drawing/2014/main" id="{846C73C5-D63B-310B-D5B5-4BFECD47FCF7}"/>
              </a:ext>
            </a:extLst>
          </p:cNvPr>
          <p:cNvSpPr txBox="1"/>
          <p:nvPr/>
        </p:nvSpPr>
        <p:spPr>
          <a:xfrm>
            <a:off x="6415314" y="1135863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12" name="CuadroTexto 211">
            <a:extLst>
              <a:ext uri="{FF2B5EF4-FFF2-40B4-BE49-F238E27FC236}">
                <a16:creationId xmlns:a16="http://schemas.microsoft.com/office/drawing/2014/main" id="{E6278CC3-07CA-D64C-59FB-E8437BAF605F}"/>
              </a:ext>
            </a:extLst>
          </p:cNvPr>
          <p:cNvSpPr txBox="1"/>
          <p:nvPr/>
        </p:nvSpPr>
        <p:spPr>
          <a:xfrm>
            <a:off x="6721556" y="1125297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13" name="CuadroTexto 212">
            <a:extLst>
              <a:ext uri="{FF2B5EF4-FFF2-40B4-BE49-F238E27FC236}">
                <a16:creationId xmlns:a16="http://schemas.microsoft.com/office/drawing/2014/main" id="{B8E48FB0-FA58-74A5-924F-2F5029AF3FB7}"/>
              </a:ext>
            </a:extLst>
          </p:cNvPr>
          <p:cNvSpPr txBox="1"/>
          <p:nvPr/>
        </p:nvSpPr>
        <p:spPr>
          <a:xfrm>
            <a:off x="6821274" y="1106294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14" name="CuadroTexto 213">
            <a:extLst>
              <a:ext uri="{FF2B5EF4-FFF2-40B4-BE49-F238E27FC236}">
                <a16:creationId xmlns:a16="http://schemas.microsoft.com/office/drawing/2014/main" id="{2795245C-F8F8-AAF6-826E-E7F74265B711}"/>
              </a:ext>
            </a:extLst>
          </p:cNvPr>
          <p:cNvSpPr txBox="1"/>
          <p:nvPr/>
        </p:nvSpPr>
        <p:spPr>
          <a:xfrm>
            <a:off x="7107262" y="1157847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15" name="CuadroTexto 214">
            <a:extLst>
              <a:ext uri="{FF2B5EF4-FFF2-40B4-BE49-F238E27FC236}">
                <a16:creationId xmlns:a16="http://schemas.microsoft.com/office/drawing/2014/main" id="{D01D3ADF-4C2A-38B8-9A1B-D5481D5CD9B5}"/>
              </a:ext>
            </a:extLst>
          </p:cNvPr>
          <p:cNvSpPr txBox="1"/>
          <p:nvPr/>
        </p:nvSpPr>
        <p:spPr>
          <a:xfrm>
            <a:off x="7206980" y="11388442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16" name="CuadroTexto 215">
            <a:extLst>
              <a:ext uri="{FF2B5EF4-FFF2-40B4-BE49-F238E27FC236}">
                <a16:creationId xmlns:a16="http://schemas.microsoft.com/office/drawing/2014/main" id="{E00565C0-9302-E498-0409-BE3046E02283}"/>
              </a:ext>
            </a:extLst>
          </p:cNvPr>
          <p:cNvSpPr txBox="1"/>
          <p:nvPr/>
        </p:nvSpPr>
        <p:spPr>
          <a:xfrm>
            <a:off x="8337892" y="1110939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17" name="CuadroTexto 216">
            <a:extLst>
              <a:ext uri="{FF2B5EF4-FFF2-40B4-BE49-F238E27FC236}">
                <a16:creationId xmlns:a16="http://schemas.microsoft.com/office/drawing/2014/main" id="{EA216E30-1CDA-9338-8A00-F3A0DE6E97D2}"/>
              </a:ext>
            </a:extLst>
          </p:cNvPr>
          <p:cNvSpPr txBox="1"/>
          <p:nvPr/>
        </p:nvSpPr>
        <p:spPr>
          <a:xfrm>
            <a:off x="8437610" y="1091936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18" name="CuadroTexto 217">
            <a:extLst>
              <a:ext uri="{FF2B5EF4-FFF2-40B4-BE49-F238E27FC236}">
                <a16:creationId xmlns:a16="http://schemas.microsoft.com/office/drawing/2014/main" id="{09795D9B-4549-40FD-2CDA-9F43DF883289}"/>
              </a:ext>
            </a:extLst>
          </p:cNvPr>
          <p:cNvSpPr txBox="1"/>
          <p:nvPr/>
        </p:nvSpPr>
        <p:spPr>
          <a:xfrm>
            <a:off x="7931932" y="1134395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19" name="CuadroTexto 218">
            <a:extLst>
              <a:ext uri="{FF2B5EF4-FFF2-40B4-BE49-F238E27FC236}">
                <a16:creationId xmlns:a16="http://schemas.microsoft.com/office/drawing/2014/main" id="{112C7F18-69C6-2775-51F9-967426D68714}"/>
              </a:ext>
            </a:extLst>
          </p:cNvPr>
          <p:cNvSpPr txBox="1"/>
          <p:nvPr/>
        </p:nvSpPr>
        <p:spPr>
          <a:xfrm>
            <a:off x="8031650" y="11153922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20" name="CuadroTexto 219">
            <a:extLst>
              <a:ext uri="{FF2B5EF4-FFF2-40B4-BE49-F238E27FC236}">
                <a16:creationId xmlns:a16="http://schemas.microsoft.com/office/drawing/2014/main" id="{CA2A810C-A238-243A-A8A1-FC59B703C9D5}"/>
              </a:ext>
            </a:extLst>
          </p:cNvPr>
          <p:cNvSpPr txBox="1"/>
          <p:nvPr/>
        </p:nvSpPr>
        <p:spPr>
          <a:xfrm>
            <a:off x="7524931" y="1134257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21" name="CuadroTexto 220">
            <a:extLst>
              <a:ext uri="{FF2B5EF4-FFF2-40B4-BE49-F238E27FC236}">
                <a16:creationId xmlns:a16="http://schemas.microsoft.com/office/drawing/2014/main" id="{B2A47CF8-18E7-3C9D-3EB4-E3C7E116095D}"/>
              </a:ext>
            </a:extLst>
          </p:cNvPr>
          <p:cNvSpPr txBox="1"/>
          <p:nvPr/>
        </p:nvSpPr>
        <p:spPr>
          <a:xfrm>
            <a:off x="7628412" y="1118264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22" name="CuadroTexto 221">
            <a:extLst>
              <a:ext uri="{FF2B5EF4-FFF2-40B4-BE49-F238E27FC236}">
                <a16:creationId xmlns:a16="http://schemas.microsoft.com/office/drawing/2014/main" id="{E3DEEAD6-CFA5-6BAB-7B0F-3B5A5FEF8A50}"/>
              </a:ext>
            </a:extLst>
          </p:cNvPr>
          <p:cNvSpPr txBox="1"/>
          <p:nvPr/>
        </p:nvSpPr>
        <p:spPr>
          <a:xfrm>
            <a:off x="9105797" y="995196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</a:p>
        </p:txBody>
      </p:sp>
      <p:sp>
        <p:nvSpPr>
          <p:cNvPr id="223" name="CuadroTexto 222">
            <a:extLst>
              <a:ext uri="{FF2B5EF4-FFF2-40B4-BE49-F238E27FC236}">
                <a16:creationId xmlns:a16="http://schemas.microsoft.com/office/drawing/2014/main" id="{B170960D-296C-DB62-4E0D-57B8D34FBBC4}"/>
              </a:ext>
            </a:extLst>
          </p:cNvPr>
          <p:cNvSpPr txBox="1"/>
          <p:nvPr/>
        </p:nvSpPr>
        <p:spPr>
          <a:xfrm>
            <a:off x="9258796" y="978879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</a:p>
        </p:txBody>
      </p:sp>
      <p:sp>
        <p:nvSpPr>
          <p:cNvPr id="224" name="CuadroTexto 223">
            <a:extLst>
              <a:ext uri="{FF2B5EF4-FFF2-40B4-BE49-F238E27FC236}">
                <a16:creationId xmlns:a16="http://schemas.microsoft.com/office/drawing/2014/main" id="{84EBAD3D-7E2A-9685-3AE8-7BC2A716A992}"/>
              </a:ext>
            </a:extLst>
          </p:cNvPr>
          <p:cNvSpPr txBox="1"/>
          <p:nvPr/>
        </p:nvSpPr>
        <p:spPr>
          <a:xfrm>
            <a:off x="8762750" y="1159206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25" name="CuadroTexto 224">
            <a:extLst>
              <a:ext uri="{FF2B5EF4-FFF2-40B4-BE49-F238E27FC236}">
                <a16:creationId xmlns:a16="http://schemas.microsoft.com/office/drawing/2014/main" id="{DE6C12F7-B2A1-EF5C-16B0-F16DAE76011B}"/>
              </a:ext>
            </a:extLst>
          </p:cNvPr>
          <p:cNvSpPr txBox="1"/>
          <p:nvPr/>
        </p:nvSpPr>
        <p:spPr>
          <a:xfrm>
            <a:off x="8862468" y="1140203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31363787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4</TotalTime>
  <Words>143</Words>
  <Application>Microsoft Office PowerPoint</Application>
  <PresentationFormat>Personalizado</PresentationFormat>
  <Paragraphs>118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o VILLENA</dc:creator>
  <cp:lastModifiedBy>Julio Villena</cp:lastModifiedBy>
  <cp:revision>73</cp:revision>
  <dcterms:created xsi:type="dcterms:W3CDTF">2017-08-23T01:51:35Z</dcterms:created>
  <dcterms:modified xsi:type="dcterms:W3CDTF">2022-08-09T17:53:51Z</dcterms:modified>
</cp:coreProperties>
</file>